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4"/>
  </p:sldMasterIdLst>
  <p:sldIdLst>
    <p:sldId id="304" r:id="rId5"/>
    <p:sldId id="291" r:id="rId6"/>
    <p:sldId id="293" r:id="rId7"/>
    <p:sldId id="309" r:id="rId8"/>
    <p:sldId id="279" r:id="rId9"/>
    <p:sldId id="280" r:id="rId10"/>
    <p:sldId id="281" r:id="rId11"/>
    <p:sldId id="282" r:id="rId12"/>
    <p:sldId id="283" r:id="rId13"/>
    <p:sldId id="284" r:id="rId14"/>
    <p:sldId id="285" r:id="rId15"/>
    <p:sldId id="286" r:id="rId16"/>
    <p:sldId id="287" r:id="rId17"/>
    <p:sldId id="288" r:id="rId18"/>
    <p:sldId id="289" r:id="rId19"/>
    <p:sldId id="290" r:id="rId20"/>
    <p:sldId id="295" r:id="rId21"/>
    <p:sldId id="296" r:id="rId22"/>
    <p:sldId id="297" r:id="rId23"/>
    <p:sldId id="298" r:id="rId24"/>
    <p:sldId id="299" r:id="rId25"/>
    <p:sldId id="300" r:id="rId26"/>
    <p:sldId id="301" r:id="rId27"/>
    <p:sldId id="302" r:id="rId28"/>
    <p:sldId id="261" r:id="rId29"/>
    <p:sldId id="313" r:id="rId30"/>
    <p:sldId id="294" r:id="rId31"/>
    <p:sldId id="312" r:id="rId32"/>
    <p:sldId id="308" r:id="rId3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64F55A2-3F6D-4652-B7A5-DA2B2B41FB7C}" v="5" dt="2022-07-15T19:12:54.09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72" y="59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microsoft.com/office/2015/10/relationships/revisionInfo" Target="revisionInfo.xml"/><Relationship Id="rId21" Type="http://schemas.openxmlformats.org/officeDocument/2006/relationships/slide" Target="slides/slide17.xml"/><Relationship Id="rId34" Type="http://schemas.openxmlformats.org/officeDocument/2006/relationships/presProps" Target="pres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tableStyles" Target="tableStyle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viewProps" Target="viewProps.xml"/><Relationship Id="rId8" Type="http://schemas.openxmlformats.org/officeDocument/2006/relationships/slide" Target="slides/slide4.xml"/><Relationship Id="rId3" Type="http://schemas.openxmlformats.org/officeDocument/2006/relationships/customXml" Target="../customXml/item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oia Heravi" userId="064cf5ee-fdb5-4524-a75f-f0672f9a7bc3" providerId="ADAL" clId="{964F55A2-3F6D-4652-B7A5-DA2B2B41FB7C}"/>
    <pc:docChg chg="undo custSel addSld delSld modSld">
      <pc:chgData name="Gioia Heravi" userId="064cf5ee-fdb5-4524-a75f-f0672f9a7bc3" providerId="ADAL" clId="{964F55A2-3F6D-4652-B7A5-DA2B2B41FB7C}" dt="2022-07-25T04:28:54.908" v="329" actId="1076"/>
      <pc:docMkLst>
        <pc:docMk/>
      </pc:docMkLst>
      <pc:sldChg chg="modSp mod">
        <pc:chgData name="Gioia Heravi" userId="064cf5ee-fdb5-4524-a75f-f0672f9a7bc3" providerId="ADAL" clId="{964F55A2-3F6D-4652-B7A5-DA2B2B41FB7C}" dt="2022-07-14T18:37:10.481" v="177"/>
        <pc:sldMkLst>
          <pc:docMk/>
          <pc:sldMk cId="2827490471" sldId="261"/>
        </pc:sldMkLst>
        <pc:spChg chg="mod">
          <ac:chgData name="Gioia Heravi" userId="064cf5ee-fdb5-4524-a75f-f0672f9a7bc3" providerId="ADAL" clId="{964F55A2-3F6D-4652-B7A5-DA2B2B41FB7C}" dt="2022-07-14T18:37:10.481" v="177"/>
          <ac:spMkLst>
            <pc:docMk/>
            <pc:sldMk cId="2827490471" sldId="261"/>
            <ac:spMk id="2" creationId="{BF190D50-A58D-40E1-A7A4-6741A234DD9B}"/>
          </ac:spMkLst>
        </pc:spChg>
      </pc:sldChg>
      <pc:sldChg chg="modSp mod">
        <pc:chgData name="Gioia Heravi" userId="064cf5ee-fdb5-4524-a75f-f0672f9a7bc3" providerId="ADAL" clId="{964F55A2-3F6D-4652-B7A5-DA2B2B41FB7C}" dt="2022-07-14T18:26:32.436" v="165" actId="1076"/>
        <pc:sldMkLst>
          <pc:docMk/>
          <pc:sldMk cId="1430368468" sldId="291"/>
        </pc:sldMkLst>
        <pc:spChg chg="mod">
          <ac:chgData name="Gioia Heravi" userId="064cf5ee-fdb5-4524-a75f-f0672f9a7bc3" providerId="ADAL" clId="{964F55A2-3F6D-4652-B7A5-DA2B2B41FB7C}" dt="2022-07-14T18:26:32.436" v="165" actId="1076"/>
          <ac:spMkLst>
            <pc:docMk/>
            <pc:sldMk cId="1430368468" sldId="291"/>
            <ac:spMk id="10" creationId="{C23EDE08-6DC3-48BB-AA30-AE8AEC6E9138}"/>
          </ac:spMkLst>
        </pc:spChg>
        <pc:graphicFrameChg chg="mod">
          <ac:chgData name="Gioia Heravi" userId="064cf5ee-fdb5-4524-a75f-f0672f9a7bc3" providerId="ADAL" clId="{964F55A2-3F6D-4652-B7A5-DA2B2B41FB7C}" dt="2022-07-14T18:26:14.868" v="159" actId="1036"/>
          <ac:graphicFrameMkLst>
            <pc:docMk/>
            <pc:sldMk cId="1430368468" sldId="291"/>
            <ac:graphicFrameMk id="6" creationId="{61859D77-DFE1-47BB-BB02-A1F309CBFA8F}"/>
          </ac:graphicFrameMkLst>
        </pc:graphicFrameChg>
        <pc:graphicFrameChg chg="mod">
          <ac:chgData name="Gioia Heravi" userId="064cf5ee-fdb5-4524-a75f-f0672f9a7bc3" providerId="ADAL" clId="{964F55A2-3F6D-4652-B7A5-DA2B2B41FB7C}" dt="2022-07-14T18:26:14.868" v="159" actId="1036"/>
          <ac:graphicFrameMkLst>
            <pc:docMk/>
            <pc:sldMk cId="1430368468" sldId="291"/>
            <ac:graphicFrameMk id="11" creationId="{2D471C1E-BC54-443D-B4D8-E4D6E902CF48}"/>
          </ac:graphicFrameMkLst>
        </pc:graphicFrameChg>
        <pc:graphicFrameChg chg="mod">
          <ac:chgData name="Gioia Heravi" userId="064cf5ee-fdb5-4524-a75f-f0672f9a7bc3" providerId="ADAL" clId="{964F55A2-3F6D-4652-B7A5-DA2B2B41FB7C}" dt="2022-07-14T18:26:14.868" v="159" actId="1036"/>
          <ac:graphicFrameMkLst>
            <pc:docMk/>
            <pc:sldMk cId="1430368468" sldId="291"/>
            <ac:graphicFrameMk id="12" creationId="{5AC5F4CA-BA52-4A50-BF48-97AB48C771D5}"/>
          </ac:graphicFrameMkLst>
        </pc:graphicFrameChg>
        <pc:graphicFrameChg chg="mod">
          <ac:chgData name="Gioia Heravi" userId="064cf5ee-fdb5-4524-a75f-f0672f9a7bc3" providerId="ADAL" clId="{964F55A2-3F6D-4652-B7A5-DA2B2B41FB7C}" dt="2022-07-14T18:26:14.868" v="159" actId="1036"/>
          <ac:graphicFrameMkLst>
            <pc:docMk/>
            <pc:sldMk cId="1430368468" sldId="291"/>
            <ac:graphicFrameMk id="13" creationId="{FA8D349D-F602-4D76-A137-FA27E6E29824}"/>
          </ac:graphicFrameMkLst>
        </pc:graphicFrameChg>
      </pc:sldChg>
      <pc:sldChg chg="delSp modSp mod">
        <pc:chgData name="Gioia Heravi" userId="064cf5ee-fdb5-4524-a75f-f0672f9a7bc3" providerId="ADAL" clId="{964F55A2-3F6D-4652-B7A5-DA2B2B41FB7C}" dt="2022-07-14T18:37:54.002" v="182" actId="14100"/>
        <pc:sldMkLst>
          <pc:docMk/>
          <pc:sldMk cId="4016828960" sldId="295"/>
        </pc:sldMkLst>
        <pc:spChg chg="mod">
          <ac:chgData name="Gioia Heravi" userId="064cf5ee-fdb5-4524-a75f-f0672f9a7bc3" providerId="ADAL" clId="{964F55A2-3F6D-4652-B7A5-DA2B2B41FB7C}" dt="2022-07-14T18:37:33.127" v="178"/>
          <ac:spMkLst>
            <pc:docMk/>
            <pc:sldMk cId="4016828960" sldId="295"/>
            <ac:spMk id="2" creationId="{7247B981-1359-4457-A2D5-BE50A13F93A6}"/>
          </ac:spMkLst>
        </pc:spChg>
        <pc:spChg chg="del mod">
          <ac:chgData name="Gioia Heravi" userId="064cf5ee-fdb5-4524-a75f-f0672f9a7bc3" providerId="ADAL" clId="{964F55A2-3F6D-4652-B7A5-DA2B2B41FB7C}" dt="2022-07-14T18:37:40.375" v="180" actId="478"/>
          <ac:spMkLst>
            <pc:docMk/>
            <pc:sldMk cId="4016828960" sldId="295"/>
            <ac:spMk id="6" creationId="{D30D3147-978E-416B-9651-74505068C112}"/>
          </ac:spMkLst>
        </pc:spChg>
        <pc:picChg chg="mod">
          <ac:chgData name="Gioia Heravi" userId="064cf5ee-fdb5-4524-a75f-f0672f9a7bc3" providerId="ADAL" clId="{964F55A2-3F6D-4652-B7A5-DA2B2B41FB7C}" dt="2022-07-14T18:37:54.002" v="182" actId="14100"/>
          <ac:picMkLst>
            <pc:docMk/>
            <pc:sldMk cId="4016828960" sldId="295"/>
            <ac:picMk id="4" creationId="{4D64AA68-2FED-4140-A950-9DF2B3CE7E6A}"/>
          </ac:picMkLst>
        </pc:picChg>
      </pc:sldChg>
      <pc:sldChg chg="modSp mod">
        <pc:chgData name="Gioia Heravi" userId="064cf5ee-fdb5-4524-a75f-f0672f9a7bc3" providerId="ADAL" clId="{964F55A2-3F6D-4652-B7A5-DA2B2B41FB7C}" dt="2022-07-14T18:35:38.270" v="173" actId="6549"/>
        <pc:sldMkLst>
          <pc:docMk/>
          <pc:sldMk cId="1013733651" sldId="296"/>
        </pc:sldMkLst>
        <pc:spChg chg="mod">
          <ac:chgData name="Gioia Heravi" userId="064cf5ee-fdb5-4524-a75f-f0672f9a7bc3" providerId="ADAL" clId="{964F55A2-3F6D-4652-B7A5-DA2B2B41FB7C}" dt="2022-07-14T18:35:38.270" v="173" actId="6549"/>
          <ac:spMkLst>
            <pc:docMk/>
            <pc:sldMk cId="1013733651" sldId="296"/>
            <ac:spMk id="6" creationId="{00000000-0000-0000-0000-000000000000}"/>
          </ac:spMkLst>
        </pc:spChg>
      </pc:sldChg>
      <pc:sldChg chg="modSp mod">
        <pc:chgData name="Gioia Heravi" userId="064cf5ee-fdb5-4524-a75f-f0672f9a7bc3" providerId="ADAL" clId="{964F55A2-3F6D-4652-B7A5-DA2B2B41FB7C}" dt="2022-07-14T18:35:17.637" v="171"/>
        <pc:sldMkLst>
          <pc:docMk/>
          <pc:sldMk cId="1187065521" sldId="298"/>
        </pc:sldMkLst>
        <pc:spChg chg="mod">
          <ac:chgData name="Gioia Heravi" userId="064cf5ee-fdb5-4524-a75f-f0672f9a7bc3" providerId="ADAL" clId="{964F55A2-3F6D-4652-B7A5-DA2B2B41FB7C}" dt="2022-07-14T18:35:17.637" v="171"/>
          <ac:spMkLst>
            <pc:docMk/>
            <pc:sldMk cId="1187065521" sldId="298"/>
            <ac:spMk id="6" creationId="{DE4C03CB-1D7C-4270-9108-F16C6F03C2F2}"/>
          </ac:spMkLst>
        </pc:spChg>
      </pc:sldChg>
      <pc:sldChg chg="modSp mod">
        <pc:chgData name="Gioia Heravi" userId="064cf5ee-fdb5-4524-a75f-f0672f9a7bc3" providerId="ADAL" clId="{964F55A2-3F6D-4652-B7A5-DA2B2B41FB7C}" dt="2022-07-14T18:25:53.039" v="119" actId="20577"/>
        <pc:sldMkLst>
          <pc:docMk/>
          <pc:sldMk cId="1190030347" sldId="304"/>
        </pc:sldMkLst>
        <pc:spChg chg="mod">
          <ac:chgData name="Gioia Heravi" userId="064cf5ee-fdb5-4524-a75f-f0672f9a7bc3" providerId="ADAL" clId="{964F55A2-3F6D-4652-B7A5-DA2B2B41FB7C}" dt="2022-07-14T18:25:53.039" v="119" actId="20577"/>
          <ac:spMkLst>
            <pc:docMk/>
            <pc:sldMk cId="1190030347" sldId="304"/>
            <ac:spMk id="4" creationId="{6C59266C-4D93-4685-9327-C902A4D85AD5}"/>
          </ac:spMkLst>
        </pc:spChg>
      </pc:sldChg>
      <pc:sldChg chg="modSp mod">
        <pc:chgData name="Gioia Heravi" userId="064cf5ee-fdb5-4524-a75f-f0672f9a7bc3" providerId="ADAL" clId="{964F55A2-3F6D-4652-B7A5-DA2B2B41FB7C}" dt="2022-07-25T04:28:54.908" v="329" actId="1076"/>
        <pc:sldMkLst>
          <pc:docMk/>
          <pc:sldMk cId="479495598" sldId="308"/>
        </pc:sldMkLst>
        <pc:spChg chg="mod">
          <ac:chgData name="Gioia Heravi" userId="064cf5ee-fdb5-4524-a75f-f0672f9a7bc3" providerId="ADAL" clId="{964F55A2-3F6D-4652-B7A5-DA2B2B41FB7C}" dt="2022-07-25T04:28:54.908" v="329" actId="1076"/>
          <ac:spMkLst>
            <pc:docMk/>
            <pc:sldMk cId="479495598" sldId="308"/>
            <ac:spMk id="4" creationId="{2862BD2D-E9E5-4FA0-8249-541D6AFC8B3E}"/>
          </ac:spMkLst>
        </pc:spChg>
      </pc:sldChg>
      <pc:sldChg chg="modSp del mod">
        <pc:chgData name="Gioia Heravi" userId="064cf5ee-fdb5-4524-a75f-f0672f9a7bc3" providerId="ADAL" clId="{964F55A2-3F6D-4652-B7A5-DA2B2B41FB7C}" dt="2022-07-15T19:13:59.800" v="286" actId="47"/>
        <pc:sldMkLst>
          <pc:docMk/>
          <pc:sldMk cId="183481786" sldId="311"/>
        </pc:sldMkLst>
        <pc:spChg chg="mod">
          <ac:chgData name="Gioia Heravi" userId="064cf5ee-fdb5-4524-a75f-f0672f9a7bc3" providerId="ADAL" clId="{964F55A2-3F6D-4652-B7A5-DA2B2B41FB7C}" dt="2022-07-15T18:52:37.354" v="244" actId="20577"/>
          <ac:spMkLst>
            <pc:docMk/>
            <pc:sldMk cId="183481786" sldId="311"/>
            <ac:spMk id="4" creationId="{74F100C0-8639-4E78-BE17-5D87E96DC980}"/>
          </ac:spMkLst>
        </pc:spChg>
        <pc:picChg chg="mod">
          <ac:chgData name="Gioia Heravi" userId="064cf5ee-fdb5-4524-a75f-f0672f9a7bc3" providerId="ADAL" clId="{964F55A2-3F6D-4652-B7A5-DA2B2B41FB7C}" dt="2022-07-15T18:53:38.261" v="245" actId="1076"/>
          <ac:picMkLst>
            <pc:docMk/>
            <pc:sldMk cId="183481786" sldId="311"/>
            <ac:picMk id="10" creationId="{C096BF28-2E0D-4326-A9D0-15E788907250}"/>
          </ac:picMkLst>
        </pc:picChg>
      </pc:sldChg>
      <pc:sldChg chg="addSp delSp modSp new mod">
        <pc:chgData name="Gioia Heravi" userId="064cf5ee-fdb5-4524-a75f-f0672f9a7bc3" providerId="ADAL" clId="{964F55A2-3F6D-4652-B7A5-DA2B2B41FB7C}" dt="2022-07-14T18:45:45.362" v="188" actId="962"/>
        <pc:sldMkLst>
          <pc:docMk/>
          <pc:sldMk cId="2041925419" sldId="312"/>
        </pc:sldMkLst>
        <pc:spChg chg="del mod">
          <ac:chgData name="Gioia Heravi" userId="064cf5ee-fdb5-4524-a75f-f0672f9a7bc3" providerId="ADAL" clId="{964F55A2-3F6D-4652-B7A5-DA2B2B41FB7C}" dt="2022-07-13T06:53:17.430" v="7" actId="478"/>
          <ac:spMkLst>
            <pc:docMk/>
            <pc:sldMk cId="2041925419" sldId="312"/>
            <ac:spMk id="2" creationId="{64B2C285-EB2B-E550-2254-194C646100D6}"/>
          </ac:spMkLst>
        </pc:spChg>
        <pc:spChg chg="del">
          <ac:chgData name="Gioia Heravi" userId="064cf5ee-fdb5-4524-a75f-f0672f9a7bc3" providerId="ADAL" clId="{964F55A2-3F6D-4652-B7A5-DA2B2B41FB7C}" dt="2022-07-13T06:53:15.100" v="5" actId="478"/>
          <ac:spMkLst>
            <pc:docMk/>
            <pc:sldMk cId="2041925419" sldId="312"/>
            <ac:spMk id="3" creationId="{135F517A-6ED2-4920-F20E-91E380C428EC}"/>
          </ac:spMkLst>
        </pc:spChg>
        <pc:spChg chg="add mod">
          <ac:chgData name="Gioia Heravi" userId="064cf5ee-fdb5-4524-a75f-f0672f9a7bc3" providerId="ADAL" clId="{964F55A2-3F6D-4652-B7A5-DA2B2B41FB7C}" dt="2022-07-14T18:42:24.931" v="183" actId="1076"/>
          <ac:spMkLst>
            <pc:docMk/>
            <pc:sldMk cId="2041925419" sldId="312"/>
            <ac:spMk id="4" creationId="{3174C6C2-E271-9DE4-2182-748A02A46019}"/>
          </ac:spMkLst>
        </pc:spChg>
        <pc:picChg chg="add mod">
          <ac:chgData name="Gioia Heravi" userId="064cf5ee-fdb5-4524-a75f-f0672f9a7bc3" providerId="ADAL" clId="{964F55A2-3F6D-4652-B7A5-DA2B2B41FB7C}" dt="2022-07-14T18:45:45.362" v="188" actId="962"/>
          <ac:picMkLst>
            <pc:docMk/>
            <pc:sldMk cId="2041925419" sldId="312"/>
            <ac:picMk id="3" creationId="{2C78D614-0673-4B5E-95A4-E11C4346DF81}"/>
          </ac:picMkLst>
        </pc:picChg>
        <pc:picChg chg="add del mod">
          <ac:chgData name="Gioia Heravi" userId="064cf5ee-fdb5-4524-a75f-f0672f9a7bc3" providerId="ADAL" clId="{964F55A2-3F6D-4652-B7A5-DA2B2B41FB7C}" dt="2022-07-14T18:45:02.405" v="185" actId="478"/>
          <ac:picMkLst>
            <pc:docMk/>
            <pc:sldMk cId="2041925419" sldId="312"/>
            <ac:picMk id="5" creationId="{AAA55B13-1969-3C28-E97E-E4450A21990A}"/>
          </ac:picMkLst>
        </pc:picChg>
      </pc:sldChg>
      <pc:sldChg chg="addSp delSp modSp new mod">
        <pc:chgData name="Gioia Heravi" userId="064cf5ee-fdb5-4524-a75f-f0672f9a7bc3" providerId="ADAL" clId="{964F55A2-3F6D-4652-B7A5-DA2B2B41FB7C}" dt="2022-07-15T19:27:24.280" v="328" actId="1076"/>
        <pc:sldMkLst>
          <pc:docMk/>
          <pc:sldMk cId="2638370696" sldId="313"/>
        </pc:sldMkLst>
        <pc:spChg chg="del">
          <ac:chgData name="Gioia Heravi" userId="064cf5ee-fdb5-4524-a75f-f0672f9a7bc3" providerId="ADAL" clId="{964F55A2-3F6D-4652-B7A5-DA2B2B41FB7C}" dt="2022-07-15T18:55:06.577" v="248" actId="478"/>
          <ac:spMkLst>
            <pc:docMk/>
            <pc:sldMk cId="2638370696" sldId="313"/>
            <ac:spMk id="2" creationId="{763B5D40-DBB7-94F1-7AAC-DB4F1F6AF118}"/>
          </ac:spMkLst>
        </pc:spChg>
        <pc:spChg chg="del">
          <ac:chgData name="Gioia Heravi" userId="064cf5ee-fdb5-4524-a75f-f0672f9a7bc3" providerId="ADAL" clId="{964F55A2-3F6D-4652-B7A5-DA2B2B41FB7C}" dt="2022-07-15T18:55:05.359" v="247" actId="478"/>
          <ac:spMkLst>
            <pc:docMk/>
            <pc:sldMk cId="2638370696" sldId="313"/>
            <ac:spMk id="3" creationId="{0C466E19-FA3A-D7EA-AFEA-4D2AC7DAF1E0}"/>
          </ac:spMkLst>
        </pc:spChg>
        <pc:spChg chg="add mod">
          <ac:chgData name="Gioia Heravi" userId="064cf5ee-fdb5-4524-a75f-f0672f9a7bc3" providerId="ADAL" clId="{964F55A2-3F6D-4652-B7A5-DA2B2B41FB7C}" dt="2022-07-15T19:27:24.280" v="328" actId="1076"/>
          <ac:spMkLst>
            <pc:docMk/>
            <pc:sldMk cId="2638370696" sldId="313"/>
            <ac:spMk id="5" creationId="{1FA885B0-4B41-D0D7-944F-414B881DD5E0}"/>
          </ac:spMkLst>
        </pc:spChg>
        <pc:picChg chg="add del mod modCrop">
          <ac:chgData name="Gioia Heravi" userId="064cf5ee-fdb5-4524-a75f-f0672f9a7bc3" providerId="ADAL" clId="{964F55A2-3F6D-4652-B7A5-DA2B2B41FB7C}" dt="2022-07-15T18:57:34.406" v="273" actId="478"/>
          <ac:picMkLst>
            <pc:docMk/>
            <pc:sldMk cId="2638370696" sldId="313"/>
            <ac:picMk id="7" creationId="{087C8AEA-254C-1868-2D07-BE65062E29E5}"/>
          </ac:picMkLst>
        </pc:picChg>
        <pc:picChg chg="add mod modCrop">
          <ac:chgData name="Gioia Heravi" userId="064cf5ee-fdb5-4524-a75f-f0672f9a7bc3" providerId="ADAL" clId="{964F55A2-3F6D-4652-B7A5-DA2B2B41FB7C}" dt="2022-07-15T19:27:21.540" v="327" actId="1036"/>
          <ac:picMkLst>
            <pc:docMk/>
            <pc:sldMk cId="2638370696" sldId="313"/>
            <ac:picMk id="9" creationId="{77EABCAA-35A8-701B-86E2-08BF5B509E6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909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910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283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338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03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102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537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03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77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91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81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A4FFE-98FC-44DC-995A-5018CCD0B4CE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07BF8-158F-4900-AFBA-701448F599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722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6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7" Type="http://schemas.openxmlformats.org/officeDocument/2006/relationships/image" Target="../media/image42.tiff"/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tiff"/><Relationship Id="rId5" Type="http://schemas.openxmlformats.org/officeDocument/2006/relationships/image" Target="../media/image40.tiff"/><Relationship Id="rId4" Type="http://schemas.openxmlformats.org/officeDocument/2006/relationships/image" Target="../media/image39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7" Type="http://schemas.openxmlformats.org/officeDocument/2006/relationships/image" Target="../media/image48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tiff"/><Relationship Id="rId5" Type="http://schemas.openxmlformats.org/officeDocument/2006/relationships/image" Target="../media/image46.tiff"/><Relationship Id="rId4" Type="http://schemas.openxmlformats.org/officeDocument/2006/relationships/image" Target="../media/image45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tiff"/><Relationship Id="rId7" Type="http://schemas.openxmlformats.org/officeDocument/2006/relationships/image" Target="../media/image54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tiff"/><Relationship Id="rId5" Type="http://schemas.openxmlformats.org/officeDocument/2006/relationships/image" Target="../media/image52.tiff"/><Relationship Id="rId4" Type="http://schemas.openxmlformats.org/officeDocument/2006/relationships/image" Target="../media/image51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tiff"/><Relationship Id="rId7" Type="http://schemas.openxmlformats.org/officeDocument/2006/relationships/image" Target="../media/image60.tiff"/><Relationship Id="rId2" Type="http://schemas.openxmlformats.org/officeDocument/2006/relationships/image" Target="../media/image5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tiff"/><Relationship Id="rId5" Type="http://schemas.openxmlformats.org/officeDocument/2006/relationships/image" Target="../media/image58.tiff"/><Relationship Id="rId4" Type="http://schemas.openxmlformats.org/officeDocument/2006/relationships/image" Target="../media/image57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tiff"/><Relationship Id="rId2" Type="http://schemas.openxmlformats.org/officeDocument/2006/relationships/image" Target="../media/image6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4.tiff"/><Relationship Id="rId4" Type="http://schemas.openxmlformats.org/officeDocument/2006/relationships/image" Target="../media/image63.tif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image" Target="../media/image6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9.tiff"/><Relationship Id="rId4" Type="http://schemas.openxmlformats.org/officeDocument/2006/relationships/image" Target="../media/image68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tiff"/><Relationship Id="rId2" Type="http://schemas.openxmlformats.org/officeDocument/2006/relationships/image" Target="../media/image7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3.tiff"/><Relationship Id="rId4" Type="http://schemas.openxmlformats.org/officeDocument/2006/relationships/image" Target="../media/image7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tiff"/><Relationship Id="rId2" Type="http://schemas.openxmlformats.org/officeDocument/2006/relationships/image" Target="../media/image7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7.tiff"/><Relationship Id="rId4" Type="http://schemas.openxmlformats.org/officeDocument/2006/relationships/image" Target="../media/image76.tif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tiff"/><Relationship Id="rId2" Type="http://schemas.openxmlformats.org/officeDocument/2006/relationships/image" Target="../media/image7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1.tiff"/><Relationship Id="rId4" Type="http://schemas.openxmlformats.org/officeDocument/2006/relationships/image" Target="../media/image80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tiff"/><Relationship Id="rId2" Type="http://schemas.openxmlformats.org/officeDocument/2006/relationships/image" Target="../media/image8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5.tiff"/><Relationship Id="rId4" Type="http://schemas.openxmlformats.org/officeDocument/2006/relationships/image" Target="../media/image84.tif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tiff"/><Relationship Id="rId2" Type="http://schemas.openxmlformats.org/officeDocument/2006/relationships/image" Target="../media/image8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9.tiff"/><Relationship Id="rId4" Type="http://schemas.openxmlformats.org/officeDocument/2006/relationships/image" Target="../media/image88.tiff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0.tif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1.tiff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2.tif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7" Type="http://schemas.openxmlformats.org/officeDocument/2006/relationships/image" Target="../media/image10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7" Type="http://schemas.openxmlformats.org/officeDocument/2006/relationships/image" Target="../media/image22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C59266C-4D93-4685-9327-C902A4D85AD5}"/>
              </a:ext>
            </a:extLst>
          </p:cNvPr>
          <p:cNvSpPr txBox="1"/>
          <p:nvPr/>
        </p:nvSpPr>
        <p:spPr>
          <a:xfrm>
            <a:off x="1116892" y="247960"/>
            <a:ext cx="6910211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Table S1. Patient baseline characteristics. </a:t>
            </a:r>
            <a:r>
              <a:rPr lang="en-US" sz="1600" dirty="0"/>
              <a:t>FADS1 RNA expression level is normalized by z-score.</a:t>
            </a:r>
            <a:endParaRPr lang="en-US" dirty="0"/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AE4AF6ED-8C06-464E-98E2-A6A1C16D82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9819819"/>
              </p:ext>
            </p:extLst>
          </p:nvPr>
        </p:nvGraphicFramePr>
        <p:xfrm>
          <a:off x="1484311" y="1077622"/>
          <a:ext cx="6175375" cy="1565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6174784" imgH="1566851" progId="Word.Document.12">
                  <p:embed/>
                </p:oleObj>
              </mc:Choice>
              <mc:Fallback>
                <p:oleObj name="Document" r:id="rId2" imgW="6174784" imgH="1566851" progId="Word.Document.12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AE4AF6ED-8C06-464E-98E2-A6A1C16D82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84311" y="1077622"/>
                        <a:ext cx="6175375" cy="1565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900303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192" y="1063082"/>
            <a:ext cx="3114185" cy="27249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015" y="1045199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815" y="1075596"/>
            <a:ext cx="3114185" cy="2724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2" y="3805877"/>
            <a:ext cx="3114185" cy="272491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5175" y="3897068"/>
            <a:ext cx="3114185" cy="272491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DDA556B-3DBA-4EE5-95EB-BC21EC1D7DE6}"/>
              </a:ext>
            </a:extLst>
          </p:cNvPr>
          <p:cNvSpPr txBox="1"/>
          <p:nvPr/>
        </p:nvSpPr>
        <p:spPr>
          <a:xfrm>
            <a:off x="204192" y="102615"/>
            <a:ext cx="8774653" cy="662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1. Kaplan-Meier (KM) plots of OS for each cancer type. BB) TGCT, CC) THCA, DD) THYM, EE) UCEC, FF) UV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C548FE3-681E-48CF-90C7-B6C2839C4E39}"/>
              </a:ext>
            </a:extLst>
          </p:cNvPr>
          <p:cNvSpPr txBox="1"/>
          <p:nvPr/>
        </p:nvSpPr>
        <p:spPr>
          <a:xfrm>
            <a:off x="633984" y="890930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66984F-A268-4C19-869D-6A7B43AEEFCE}"/>
              </a:ext>
            </a:extLst>
          </p:cNvPr>
          <p:cNvSpPr txBox="1"/>
          <p:nvPr/>
        </p:nvSpPr>
        <p:spPr>
          <a:xfrm>
            <a:off x="3589416" y="979036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19E711B-AEF5-4694-9723-D2485C9795DF}"/>
              </a:ext>
            </a:extLst>
          </p:cNvPr>
          <p:cNvSpPr txBox="1"/>
          <p:nvPr/>
        </p:nvSpPr>
        <p:spPr>
          <a:xfrm>
            <a:off x="6538598" y="979036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89BF9A-7879-4916-A72B-60C2738AF0AC}"/>
              </a:ext>
            </a:extLst>
          </p:cNvPr>
          <p:cNvSpPr txBox="1"/>
          <p:nvPr/>
        </p:nvSpPr>
        <p:spPr>
          <a:xfrm>
            <a:off x="633984" y="3787994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F8E2B3-32EB-47C7-845D-63A9A8AE73FE}"/>
              </a:ext>
            </a:extLst>
          </p:cNvPr>
          <p:cNvSpPr txBox="1"/>
          <p:nvPr/>
        </p:nvSpPr>
        <p:spPr>
          <a:xfrm>
            <a:off x="3635542" y="3800508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F</a:t>
            </a:r>
          </a:p>
        </p:txBody>
      </p:sp>
    </p:spTree>
    <p:extLst>
      <p:ext uri="{BB962C8B-B14F-4D97-AF65-F5344CB8AC3E}">
        <p14:creationId xmlns:p14="http://schemas.microsoft.com/office/powerpoint/2010/main" val="20245093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85230"/>
            <a:ext cx="3114185" cy="27249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2719" y="1485230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815" y="1485230"/>
            <a:ext cx="3114185" cy="27249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34112" y="115860"/>
            <a:ext cx="87172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Figure S2. Kaplan-Meier (KM) plots of DFS for each cancer types . </a:t>
            </a:r>
          </a:p>
          <a:p>
            <a:pPr algn="ctr"/>
            <a:r>
              <a:rPr lang="en-US" b="1" dirty="0"/>
              <a:t>A) All Cancers, B) Brain cancers, C) Non-brain cancer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AE8321-5CB6-4A99-9B9F-9F4B65B9CEE8}"/>
              </a:ext>
            </a:extLst>
          </p:cNvPr>
          <p:cNvSpPr txBox="1"/>
          <p:nvPr/>
        </p:nvSpPr>
        <p:spPr>
          <a:xfrm>
            <a:off x="576783" y="1475705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03E3D0C-B788-4EBE-9155-158E1085404C}"/>
              </a:ext>
            </a:extLst>
          </p:cNvPr>
          <p:cNvSpPr txBox="1"/>
          <p:nvPr/>
        </p:nvSpPr>
        <p:spPr>
          <a:xfrm>
            <a:off x="3412999" y="148523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D81925-C3AA-440F-B949-D8FC1A0BEE2F}"/>
              </a:ext>
            </a:extLst>
          </p:cNvPr>
          <p:cNvSpPr txBox="1"/>
          <p:nvPr/>
        </p:nvSpPr>
        <p:spPr>
          <a:xfrm>
            <a:off x="6582554" y="1467558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3407696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45" y="830860"/>
            <a:ext cx="3114185" cy="27249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3485" y="884839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6904" y="765667"/>
            <a:ext cx="3114185" cy="2724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44" y="3927738"/>
            <a:ext cx="3114185" cy="272491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375" y="3927738"/>
            <a:ext cx="3114185" cy="272491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6906" y="3862545"/>
            <a:ext cx="3114185" cy="272491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A06944B-2F86-4F08-B011-AFF55A0F674A}"/>
              </a:ext>
            </a:extLst>
          </p:cNvPr>
          <p:cNvSpPr txBox="1"/>
          <p:nvPr/>
        </p:nvSpPr>
        <p:spPr>
          <a:xfrm>
            <a:off x="112910" y="115861"/>
            <a:ext cx="89181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2. Kaplan-Meier (KM) plots of DFS for each cancer typ. D) ACC, E)BLCA, F) BRCA, G) CESC, H) CHOL, I) COADREA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6CBE52E-B1AC-4F64-96C9-5472B2C26595}"/>
              </a:ext>
            </a:extLst>
          </p:cNvPr>
          <p:cNvSpPr txBox="1"/>
          <p:nvPr/>
        </p:nvSpPr>
        <p:spPr>
          <a:xfrm>
            <a:off x="540207" y="774698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E1564A5-D43C-4E00-B497-F4CB1AFC5C8D}"/>
              </a:ext>
            </a:extLst>
          </p:cNvPr>
          <p:cNvSpPr txBox="1"/>
          <p:nvPr/>
        </p:nvSpPr>
        <p:spPr>
          <a:xfrm>
            <a:off x="3531598" y="76786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2E1139-37C5-4240-A2D1-D01F8378A1BE}"/>
              </a:ext>
            </a:extLst>
          </p:cNvPr>
          <p:cNvSpPr txBox="1"/>
          <p:nvPr/>
        </p:nvSpPr>
        <p:spPr>
          <a:xfrm>
            <a:off x="6433270" y="795906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53F5A1E-DD86-447B-9C46-3EFEB47F7EAE}"/>
              </a:ext>
            </a:extLst>
          </p:cNvPr>
          <p:cNvSpPr txBox="1"/>
          <p:nvPr/>
        </p:nvSpPr>
        <p:spPr>
          <a:xfrm>
            <a:off x="540207" y="377841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4DE3994-0380-4B36-843E-610039EF52C9}"/>
              </a:ext>
            </a:extLst>
          </p:cNvPr>
          <p:cNvSpPr txBox="1"/>
          <p:nvPr/>
        </p:nvSpPr>
        <p:spPr>
          <a:xfrm>
            <a:off x="3578122" y="38579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45E4EC-076D-437D-824D-2FDE10DBB724}"/>
              </a:ext>
            </a:extLst>
          </p:cNvPr>
          <p:cNvSpPr txBox="1"/>
          <p:nvPr/>
        </p:nvSpPr>
        <p:spPr>
          <a:xfrm>
            <a:off x="6433270" y="38579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426991599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6344"/>
            <a:ext cx="3114185" cy="272491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030" y="749065"/>
            <a:ext cx="3114185" cy="272491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02" y="749065"/>
            <a:ext cx="3114185" cy="272491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791256"/>
            <a:ext cx="3114185" cy="272491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017" y="3773977"/>
            <a:ext cx="3114185" cy="2724912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6904" y="3791256"/>
            <a:ext cx="3114185" cy="272491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961F59C-9134-4D10-9F35-ADE47B343354}"/>
              </a:ext>
            </a:extLst>
          </p:cNvPr>
          <p:cNvSpPr txBox="1"/>
          <p:nvPr/>
        </p:nvSpPr>
        <p:spPr>
          <a:xfrm>
            <a:off x="210452" y="115861"/>
            <a:ext cx="8849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ontinued- Supplementary Figure S2. Kaplan-Meier (KM) plots of DFS for each cancer type.</a:t>
            </a:r>
          </a:p>
          <a:p>
            <a:pPr algn="ctr"/>
            <a:r>
              <a:rPr lang="en-US" b="1" dirty="0"/>
              <a:t>J) DLBC, K) ESCA, L) GBM, M) HNSC, N) KICH, O) KIR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D029232-28D0-4832-9F9B-90D59C955756}"/>
              </a:ext>
            </a:extLst>
          </p:cNvPr>
          <p:cNvSpPr txBox="1"/>
          <p:nvPr/>
        </p:nvSpPr>
        <p:spPr>
          <a:xfrm>
            <a:off x="540258" y="76725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B8C8974-B929-4F36-828B-2C39CE318AED}"/>
              </a:ext>
            </a:extLst>
          </p:cNvPr>
          <p:cNvSpPr txBox="1"/>
          <p:nvPr/>
        </p:nvSpPr>
        <p:spPr>
          <a:xfrm>
            <a:off x="3560064" y="756777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46B002A-171C-42F4-A425-C2FBE3ACCB3B}"/>
              </a:ext>
            </a:extLst>
          </p:cNvPr>
          <p:cNvSpPr txBox="1"/>
          <p:nvPr/>
        </p:nvSpPr>
        <p:spPr>
          <a:xfrm>
            <a:off x="6517656" y="76250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F764B6-1424-432C-BB4D-85C0F294AC79}"/>
              </a:ext>
            </a:extLst>
          </p:cNvPr>
          <p:cNvSpPr txBox="1"/>
          <p:nvPr/>
        </p:nvSpPr>
        <p:spPr>
          <a:xfrm>
            <a:off x="597408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BECF0D5-9DEA-44BA-8B72-5E84C34CBB51}"/>
              </a:ext>
            </a:extLst>
          </p:cNvPr>
          <p:cNvSpPr txBox="1"/>
          <p:nvPr/>
        </p:nvSpPr>
        <p:spPr>
          <a:xfrm>
            <a:off x="3535680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2098568-5B8E-4B6D-809E-9E898C91E951}"/>
              </a:ext>
            </a:extLst>
          </p:cNvPr>
          <p:cNvSpPr txBox="1"/>
          <p:nvPr/>
        </p:nvSpPr>
        <p:spPr>
          <a:xfrm>
            <a:off x="6494415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61667101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1344"/>
            <a:ext cx="3114185" cy="27249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1924" y="840342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6916" y="840342"/>
            <a:ext cx="3114185" cy="2724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857366"/>
            <a:ext cx="3114185" cy="272491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184" y="3787817"/>
            <a:ext cx="3114185" cy="272491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815" y="3718268"/>
            <a:ext cx="3114185" cy="272491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2F745E3-710B-499C-8969-55715F2573ED}"/>
              </a:ext>
            </a:extLst>
          </p:cNvPr>
          <p:cNvSpPr txBox="1"/>
          <p:nvPr/>
        </p:nvSpPr>
        <p:spPr>
          <a:xfrm>
            <a:off x="210451" y="115861"/>
            <a:ext cx="8849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ontinued- Supplementary Figure S2. Kaplan-Meier (KM) plots of DFS for each cancer type.</a:t>
            </a:r>
          </a:p>
          <a:p>
            <a:pPr algn="ctr"/>
            <a:r>
              <a:rPr lang="en-US" b="1" dirty="0"/>
              <a:t>P) KIRP, Q) LGG, R) LIHC, S) LUAD, T) LUSC, U) OV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FF07E58-DF9B-43BA-AB46-89FCBDBE9DD9}"/>
              </a:ext>
            </a:extLst>
          </p:cNvPr>
          <p:cNvSpPr txBox="1"/>
          <p:nvPr/>
        </p:nvSpPr>
        <p:spPr>
          <a:xfrm>
            <a:off x="521229" y="798754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EF2F927-FADD-4427-BA33-F1FCFC7C1AA1}"/>
              </a:ext>
            </a:extLst>
          </p:cNvPr>
          <p:cNvSpPr txBox="1"/>
          <p:nvPr/>
        </p:nvSpPr>
        <p:spPr>
          <a:xfrm>
            <a:off x="3507812" y="831741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Q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328339-BB8C-4625-98D7-7B3E472B32B7}"/>
              </a:ext>
            </a:extLst>
          </p:cNvPr>
          <p:cNvSpPr txBox="1"/>
          <p:nvPr/>
        </p:nvSpPr>
        <p:spPr>
          <a:xfrm>
            <a:off x="6532114" y="809139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B155B1-FF62-4125-A18E-EFDD4590192B}"/>
              </a:ext>
            </a:extLst>
          </p:cNvPr>
          <p:cNvSpPr txBox="1"/>
          <p:nvPr/>
        </p:nvSpPr>
        <p:spPr>
          <a:xfrm>
            <a:off x="597408" y="3787484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C32F275-4C62-4AB9-A361-D4E1CC4B38F1}"/>
              </a:ext>
            </a:extLst>
          </p:cNvPr>
          <p:cNvSpPr txBox="1"/>
          <p:nvPr/>
        </p:nvSpPr>
        <p:spPr>
          <a:xfrm>
            <a:off x="3654116" y="373160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CBFAF9-9E6F-4EE2-B0BB-5682C09B0F16}"/>
              </a:ext>
            </a:extLst>
          </p:cNvPr>
          <p:cNvSpPr txBox="1"/>
          <p:nvPr/>
        </p:nvSpPr>
        <p:spPr>
          <a:xfrm>
            <a:off x="6621997" y="371826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</a:t>
            </a:r>
          </a:p>
        </p:txBody>
      </p:sp>
    </p:spTree>
    <p:extLst>
      <p:ext uri="{BB962C8B-B14F-4D97-AF65-F5344CB8AC3E}">
        <p14:creationId xmlns:p14="http://schemas.microsoft.com/office/powerpoint/2010/main" val="24246446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69" y="906920"/>
            <a:ext cx="3114185" cy="272491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3919" y="983547"/>
            <a:ext cx="3114185" cy="272491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7448" y="963819"/>
            <a:ext cx="3114185" cy="272491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63" y="3832640"/>
            <a:ext cx="3114185" cy="272491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921" y="3861499"/>
            <a:ext cx="3114185" cy="2724912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3842" y="3890358"/>
            <a:ext cx="3114185" cy="272491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5927E29-EB77-4C35-A2F5-FF1167BCA7AA}"/>
              </a:ext>
            </a:extLst>
          </p:cNvPr>
          <p:cNvSpPr txBox="1"/>
          <p:nvPr/>
        </p:nvSpPr>
        <p:spPr>
          <a:xfrm>
            <a:off x="210452" y="115861"/>
            <a:ext cx="8849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ontinued- Supplementary Figure S2. Kaplan-Meier (KM) plots of DFS for each cancer type.</a:t>
            </a:r>
          </a:p>
          <a:p>
            <a:pPr algn="ctr"/>
            <a:r>
              <a:rPr lang="en-US" b="1" dirty="0"/>
              <a:t>V) PAAD, W) PRAD, X) SARC, Y) SKCM, Z) STAD, AA) TGC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9AFF117-9FCD-4906-8E87-3D246A0402E6}"/>
              </a:ext>
            </a:extLst>
          </p:cNvPr>
          <p:cNvSpPr txBox="1"/>
          <p:nvPr/>
        </p:nvSpPr>
        <p:spPr>
          <a:xfrm>
            <a:off x="597408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3003F7-CE60-48F1-A9B8-D96A0D0FD824}"/>
              </a:ext>
            </a:extLst>
          </p:cNvPr>
          <p:cNvSpPr txBox="1"/>
          <p:nvPr/>
        </p:nvSpPr>
        <p:spPr>
          <a:xfrm>
            <a:off x="3458979" y="90692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F7B576E-7FF7-498C-B8D8-6B6D19AFA3D1}"/>
              </a:ext>
            </a:extLst>
          </p:cNvPr>
          <p:cNvSpPr txBox="1"/>
          <p:nvPr/>
        </p:nvSpPr>
        <p:spPr>
          <a:xfrm>
            <a:off x="6539264" y="90736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AB24B61-FA5E-4FAD-8A61-18DD306FAE48}"/>
              </a:ext>
            </a:extLst>
          </p:cNvPr>
          <p:cNvSpPr txBox="1"/>
          <p:nvPr/>
        </p:nvSpPr>
        <p:spPr>
          <a:xfrm>
            <a:off x="597408" y="3778973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Y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145FA1F-16B4-4A27-BBF7-E8F09396DB2E}"/>
              </a:ext>
            </a:extLst>
          </p:cNvPr>
          <p:cNvSpPr txBox="1"/>
          <p:nvPr/>
        </p:nvSpPr>
        <p:spPr>
          <a:xfrm>
            <a:off x="3535493" y="3805437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2BB5E9E-762A-4C7C-8394-21FBD1E26F19}"/>
              </a:ext>
            </a:extLst>
          </p:cNvPr>
          <p:cNvSpPr txBox="1"/>
          <p:nvPr/>
        </p:nvSpPr>
        <p:spPr>
          <a:xfrm>
            <a:off x="6522899" y="3801266"/>
            <a:ext cx="471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A</a:t>
            </a:r>
          </a:p>
        </p:txBody>
      </p:sp>
    </p:spTree>
    <p:extLst>
      <p:ext uri="{BB962C8B-B14F-4D97-AF65-F5344CB8AC3E}">
        <p14:creationId xmlns:p14="http://schemas.microsoft.com/office/powerpoint/2010/main" val="33661998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248" y="933443"/>
            <a:ext cx="3114185" cy="27249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032" y="970268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5612" y="1007093"/>
            <a:ext cx="3114185" cy="2724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66" y="3824819"/>
            <a:ext cx="3114185" cy="27249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1A24DD6-3573-4115-BFDA-DD1AB0A48DA3}"/>
              </a:ext>
            </a:extLst>
          </p:cNvPr>
          <p:cNvSpPr txBox="1"/>
          <p:nvPr/>
        </p:nvSpPr>
        <p:spPr>
          <a:xfrm>
            <a:off x="210451" y="115861"/>
            <a:ext cx="884934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ontinued- Supplementary Figure S2. Kaplan-Meier (KM) plots of DFS for each cancer type.</a:t>
            </a:r>
          </a:p>
          <a:p>
            <a:pPr algn="ctr"/>
            <a:r>
              <a:rPr lang="en-US" b="1" dirty="0"/>
              <a:t>BB) THCA, CC) THYM, DD) UCEC, EE) UVM</a:t>
            </a:r>
          </a:p>
          <a:p>
            <a:pPr algn="ctr"/>
            <a:endParaRPr lang="en-US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A23B04-DCF1-4C85-9014-965DF639A801}"/>
              </a:ext>
            </a:extLst>
          </p:cNvPr>
          <p:cNvSpPr txBox="1"/>
          <p:nvPr/>
        </p:nvSpPr>
        <p:spPr>
          <a:xfrm>
            <a:off x="646176" y="854525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01BE3F-02E4-41AD-86A8-338AF21DBD69}"/>
              </a:ext>
            </a:extLst>
          </p:cNvPr>
          <p:cNvSpPr txBox="1"/>
          <p:nvPr/>
        </p:nvSpPr>
        <p:spPr>
          <a:xfrm>
            <a:off x="3652318" y="940543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E386DF-E83A-4FF7-AE69-193E7F652BAB}"/>
              </a:ext>
            </a:extLst>
          </p:cNvPr>
          <p:cNvSpPr txBox="1"/>
          <p:nvPr/>
        </p:nvSpPr>
        <p:spPr>
          <a:xfrm>
            <a:off x="6538598" y="979036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7F211E-7B11-43D9-89D3-21AA83986CC0}"/>
              </a:ext>
            </a:extLst>
          </p:cNvPr>
          <p:cNvSpPr txBox="1"/>
          <p:nvPr/>
        </p:nvSpPr>
        <p:spPr>
          <a:xfrm>
            <a:off x="633984" y="3787994"/>
            <a:ext cx="475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E</a:t>
            </a:r>
          </a:p>
        </p:txBody>
      </p:sp>
    </p:spTree>
    <p:extLst>
      <p:ext uri="{BB962C8B-B14F-4D97-AF65-F5344CB8AC3E}">
        <p14:creationId xmlns:p14="http://schemas.microsoft.com/office/powerpoint/2010/main" val="351675903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D64AA68-2FED-4140-A950-9DF2B3CE7E6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674" y="3482259"/>
            <a:ext cx="5962650" cy="279926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7247B981-1359-4457-A2D5-BE50A13F93A6}"/>
              </a:ext>
            </a:extLst>
          </p:cNvPr>
          <p:cNvSpPr/>
          <p:nvPr/>
        </p:nvSpPr>
        <p:spPr>
          <a:xfrm>
            <a:off x="560831" y="236421"/>
            <a:ext cx="8022336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. The mRNA expression levels of FADS1 according to sample type in non-brain cancer types. 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median (IQR) is 9.09 (8.13,10.21), 9.45 (8.47,10.37), 10.36 (9.71,10.94), 10.77 (10.17,11.96), 10.34 (9.81,10.71) for ‘Solid Tissue Normal’, ‘Primary Tumor’, ‘Metastatic’, ‘Recurrent Tumor’, ‘Primary Blood Derived Cancer - Peripheral Blood’, respectively. The p-value was obtained by Kruskal-Wallis test. All post-hoc p values for pairwise comparisons were less than 0.001 except for the three pairwise comparisons between ‘Metastatic’ and  ‘Recurrent Tumor’ (Wilcoxon post-hoc p=0.107), between ‘Metastatic’ and ‘Primary Blood Derived Cancer - Peripheral Blood’ (Wilcoxon post-hoc p=0.184),  and between ‘Recurrent Tumor’ and ‘Primary Blood Derived Cancer - Peripheral Blood’ (Wilcoxon post-hoc p=0.061). </a:t>
            </a:r>
            <a:r>
              <a:rPr lang="en-US" sz="1800" dirty="0"/>
              <a:t>FADS1 RNA expression level is normalized by z-scor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682896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8736" y="3786251"/>
            <a:ext cx="2743200" cy="219456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4376" y="1338806"/>
            <a:ext cx="3931920" cy="21945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553" y="3786251"/>
            <a:ext cx="3931920" cy="21945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979" y="1338806"/>
            <a:ext cx="2743200" cy="219456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. The mRNA expression levels of FADS1 according to sample type for each cancer type. A) BLCA, B) BRCA, C)CESC, D)CHOL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</a:t>
            </a:r>
            <a:endParaRPr lang="en-US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1A5EAB-45C5-498D-8059-EFA89B398086}"/>
              </a:ext>
            </a:extLst>
          </p:cNvPr>
          <p:cNvSpPr txBox="1"/>
          <p:nvPr/>
        </p:nvSpPr>
        <p:spPr>
          <a:xfrm>
            <a:off x="1511808" y="1254930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1BC88C-713E-4B1C-93F6-54F363C2BCE6}"/>
              </a:ext>
            </a:extLst>
          </p:cNvPr>
          <p:cNvSpPr txBox="1"/>
          <p:nvPr/>
        </p:nvSpPr>
        <p:spPr>
          <a:xfrm>
            <a:off x="4775165" y="1254930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56BEE1-D4A1-4251-9213-C355A6DC614B}"/>
              </a:ext>
            </a:extLst>
          </p:cNvPr>
          <p:cNvSpPr txBox="1"/>
          <p:nvPr/>
        </p:nvSpPr>
        <p:spPr>
          <a:xfrm>
            <a:off x="1117979" y="3666010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05C467D-47BA-43A9-A35D-AF53D8C8B425}"/>
              </a:ext>
            </a:extLst>
          </p:cNvPr>
          <p:cNvSpPr txBox="1"/>
          <p:nvPr/>
        </p:nvSpPr>
        <p:spPr>
          <a:xfrm>
            <a:off x="5322726" y="369018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01373365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4772" y="1627756"/>
            <a:ext cx="3931920" cy="21945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460" y="4267553"/>
            <a:ext cx="2743200" cy="219456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5715" y="4267553"/>
            <a:ext cx="3931920" cy="21945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772" y="1627756"/>
            <a:ext cx="4572000" cy="2194560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ECE0F0AF-564B-4FE7-8880-4E1552B66145}"/>
              </a:ext>
            </a:extLst>
          </p:cNvPr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E) COADREAD, F) ESCA, G) GBM, H) HNSC. 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uskal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Wallis test.</a:t>
            </a:r>
            <a:endParaRPr lang="en-US" sz="16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FE0A7C-2A09-4858-8647-0712778C21E6}"/>
              </a:ext>
            </a:extLst>
          </p:cNvPr>
          <p:cNvSpPr txBox="1"/>
          <p:nvPr/>
        </p:nvSpPr>
        <p:spPr>
          <a:xfrm>
            <a:off x="742795" y="1516652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95855C-4E36-42C2-B7D6-1E8E9D6D26B9}"/>
              </a:ext>
            </a:extLst>
          </p:cNvPr>
          <p:cNvSpPr txBox="1"/>
          <p:nvPr/>
        </p:nvSpPr>
        <p:spPr>
          <a:xfrm>
            <a:off x="5322726" y="1516652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F40121-BFCD-45AA-80A5-808EA9902D80}"/>
              </a:ext>
            </a:extLst>
          </p:cNvPr>
          <p:cNvSpPr txBox="1"/>
          <p:nvPr/>
        </p:nvSpPr>
        <p:spPr>
          <a:xfrm>
            <a:off x="1501805" y="4143847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0000209-D559-4EF1-A278-F06668985311}"/>
              </a:ext>
            </a:extLst>
          </p:cNvPr>
          <p:cNvSpPr txBox="1"/>
          <p:nvPr/>
        </p:nvSpPr>
        <p:spPr>
          <a:xfrm>
            <a:off x="5200806" y="4193991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629866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C23EDE08-6DC3-48BB-AA30-AE8AEC6E9138}"/>
              </a:ext>
            </a:extLst>
          </p:cNvPr>
          <p:cNvSpPr txBox="1"/>
          <p:nvPr/>
        </p:nvSpPr>
        <p:spPr>
          <a:xfrm>
            <a:off x="-71242" y="148288"/>
            <a:ext cx="92864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Supplementary Table S2. Patient baseline characteristics by cancer type. </a:t>
            </a:r>
          </a:p>
          <a:p>
            <a:pPr algn="ctr"/>
            <a:r>
              <a:rPr lang="en-US" sz="1800" dirty="0"/>
              <a:t>FADS1 RNA expression level is normalized by z-score.</a:t>
            </a:r>
            <a:endParaRPr lang="en-US" b="1" dirty="0"/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D471C1E-BC54-443D-B4D8-E4D6E902CF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6938228"/>
              </p:ext>
            </p:extLst>
          </p:nvPr>
        </p:nvGraphicFramePr>
        <p:xfrm>
          <a:off x="628650" y="1015440"/>
          <a:ext cx="7886700" cy="155327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3975973437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14058557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683155485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407740602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28338651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28922589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994608409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5752800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93695047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CC (N = 9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LCA (N = 41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CA (N = 110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ESC (N = 31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HOL (N = 5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OADREAD (N = 64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DLBC (N = 4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ESCA (N = 1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66274669"/>
                  </a:ext>
                </a:extLst>
              </a:tr>
              <a:tr h="565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 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drenocortica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Bladder Urothelial Carcinoma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east Invasive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ervical Squamous Cell Carcinoma and Endocervical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holangi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olorectal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ymphoid Neoplasm Diffuse Large B-cell Lymph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Esophagea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661252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FADS1 – mean (SD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0.0034 (1.0992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907 (1.053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1167 (1.583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1272 (0.931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544 (1.046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940 (1.278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2192 (1.186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778 (1.095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996241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5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58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765303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Age – median (range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8.5 (14-8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9 (34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8 (26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6 (20-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 (29-8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8 (31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7.5 (23-8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0.5 (27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543756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0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594274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Race – no. (%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086897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8 (8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28 (7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64 (6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12 (6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8 (7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98 (4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9 (6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14 (6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047860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Non-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4 (1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5 (2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44 (3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8 (3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3 (2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42 (5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9 (4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72 (39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27379934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5AC5F4CA-BA52-4A50-BF48-97AB48C771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559645"/>
              </p:ext>
            </p:extLst>
          </p:nvPr>
        </p:nvGraphicFramePr>
        <p:xfrm>
          <a:off x="628650" y="2568718"/>
          <a:ext cx="7886700" cy="1324932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286754707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61837126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97755392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1530013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531803502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26634175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447786671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548814217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221879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GBM (N = 61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HNSC (N = 53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KICH (N = 11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KIRC (N = 53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KIRP (N = 29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AML (N = 20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GG (N = 53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IHC (N = 44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92359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 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Glioblastoma Multiforme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Head and Neck Squamous Cel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Kidney Chromophobe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Kidney Renal Clear Cel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Kidney Renal Papillary Cel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cute Myeloid Leukemi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Brain Lower Grade Gli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iver Hepatocellular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665526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FADS1 – mean (SD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771 (0.989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600 (0.982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412 (0.889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604 (1.066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397 (1.002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521 (1.010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129 (1.016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529 (1.882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74619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5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9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840094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ge – median (range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9 (10-8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19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0 (17-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26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28-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7.5 (18-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1 (14-8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16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566464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4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47109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Race – no. (%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714789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18 (8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54 (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5 (8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66 (8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07 (7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81 (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88 (9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88 (4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131681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Non-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01 (1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6 (1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8 (1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2 (1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6 (2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9 (1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2 (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254 (57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56595720"/>
                  </a:ext>
                </a:extLst>
              </a:tr>
            </a:tbl>
          </a:graphicData>
        </a:graphic>
      </p:graphicFrame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FA8D349D-F602-4D76-A137-FA27E6E298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2977474"/>
              </p:ext>
            </p:extLst>
          </p:nvPr>
        </p:nvGraphicFramePr>
        <p:xfrm>
          <a:off x="628650" y="3893650"/>
          <a:ext cx="7886699" cy="155327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866775">
                  <a:extLst>
                    <a:ext uri="{9D8B030D-6E8A-4147-A177-3AD203B41FA5}">
                      <a16:colId xmlns:a16="http://schemas.microsoft.com/office/drawing/2014/main" val="2408806636"/>
                    </a:ext>
                  </a:extLst>
                </a:gridCol>
                <a:gridCol w="696369">
                  <a:extLst>
                    <a:ext uri="{9D8B030D-6E8A-4147-A177-3AD203B41FA5}">
                      <a16:colId xmlns:a16="http://schemas.microsoft.com/office/drawing/2014/main" val="2261501156"/>
                    </a:ext>
                  </a:extLst>
                </a:gridCol>
                <a:gridCol w="766587">
                  <a:extLst>
                    <a:ext uri="{9D8B030D-6E8A-4147-A177-3AD203B41FA5}">
                      <a16:colId xmlns:a16="http://schemas.microsoft.com/office/drawing/2014/main" val="4270597639"/>
                    </a:ext>
                  </a:extLst>
                </a:gridCol>
                <a:gridCol w="818639">
                  <a:extLst>
                    <a:ext uri="{9D8B030D-6E8A-4147-A177-3AD203B41FA5}">
                      <a16:colId xmlns:a16="http://schemas.microsoft.com/office/drawing/2014/main" val="3685615127"/>
                    </a:ext>
                  </a:extLst>
                </a:gridCol>
                <a:gridCol w="1134107">
                  <a:extLst>
                    <a:ext uri="{9D8B030D-6E8A-4147-A177-3AD203B41FA5}">
                      <a16:colId xmlns:a16="http://schemas.microsoft.com/office/drawing/2014/main" val="3168125836"/>
                    </a:ext>
                  </a:extLst>
                </a:gridCol>
                <a:gridCol w="927476">
                  <a:extLst>
                    <a:ext uri="{9D8B030D-6E8A-4147-A177-3AD203B41FA5}">
                      <a16:colId xmlns:a16="http://schemas.microsoft.com/office/drawing/2014/main" val="290627593"/>
                    </a:ext>
                  </a:extLst>
                </a:gridCol>
                <a:gridCol w="1146726">
                  <a:extLst>
                    <a:ext uri="{9D8B030D-6E8A-4147-A177-3AD203B41FA5}">
                      <a16:colId xmlns:a16="http://schemas.microsoft.com/office/drawing/2014/main" val="1487728866"/>
                    </a:ext>
                  </a:extLst>
                </a:gridCol>
                <a:gridCol w="906971">
                  <a:extLst>
                    <a:ext uri="{9D8B030D-6E8A-4147-A177-3AD203B41FA5}">
                      <a16:colId xmlns:a16="http://schemas.microsoft.com/office/drawing/2014/main" val="1983094985"/>
                    </a:ext>
                  </a:extLst>
                </a:gridCol>
                <a:gridCol w="623049">
                  <a:extLst>
                    <a:ext uri="{9D8B030D-6E8A-4147-A177-3AD203B41FA5}">
                      <a16:colId xmlns:a16="http://schemas.microsoft.com/office/drawing/2014/main" val="12556957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 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UAD (N = 5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USC (N = 51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ESO (N = 8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OV (N = 617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AAD (N = 1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CPG (N = 18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RAD (N = 50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ARC (N = 26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266974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ung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Lung Squamous Cel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esotheli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Ovarian Serous Cyst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ancreatic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heochromocytoma and Paragangli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Prostate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arc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489564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FADS1 – mean (SD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1957 (1.144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896 (1.088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1083 (1.103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1477 (1.328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015 (0.998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1462 (1.047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034 (1.001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480 (1.005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66951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9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1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174775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ge – median (range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6 (33-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8 (39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4 (28-8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9 (26-8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5 (35-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6 (19-8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41-7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 (20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646668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6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501058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Race – no. (%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223836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94 (6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51 (6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5 (9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14 (8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63 (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53 (8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47 (2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32 (8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223737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Non-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92 (3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60 (3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 (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03 (1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3 (1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1 (1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54 (7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33 (12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38881222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1859D77-DFE1-47BB-BB02-A1F309CBFA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5550460"/>
              </p:ext>
            </p:extLst>
          </p:nvPr>
        </p:nvGraphicFramePr>
        <p:xfrm>
          <a:off x="628650" y="5446928"/>
          <a:ext cx="7886700" cy="1262784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847725">
                  <a:extLst>
                    <a:ext uri="{9D8B030D-6E8A-4147-A177-3AD203B41FA5}">
                      <a16:colId xmlns:a16="http://schemas.microsoft.com/office/drawing/2014/main" val="3827289497"/>
                    </a:ext>
                  </a:extLst>
                </a:gridCol>
                <a:gridCol w="791459">
                  <a:extLst>
                    <a:ext uri="{9D8B030D-6E8A-4147-A177-3AD203B41FA5}">
                      <a16:colId xmlns:a16="http://schemas.microsoft.com/office/drawing/2014/main" val="1037807270"/>
                    </a:ext>
                  </a:extLst>
                </a:gridCol>
                <a:gridCol w="982880">
                  <a:extLst>
                    <a:ext uri="{9D8B030D-6E8A-4147-A177-3AD203B41FA5}">
                      <a16:colId xmlns:a16="http://schemas.microsoft.com/office/drawing/2014/main" val="2773659508"/>
                    </a:ext>
                  </a:extLst>
                </a:gridCol>
                <a:gridCol w="844046">
                  <a:extLst>
                    <a:ext uri="{9D8B030D-6E8A-4147-A177-3AD203B41FA5}">
                      <a16:colId xmlns:a16="http://schemas.microsoft.com/office/drawing/2014/main" val="1175673464"/>
                    </a:ext>
                  </a:extLst>
                </a:gridCol>
                <a:gridCol w="765163">
                  <a:extLst>
                    <a:ext uri="{9D8B030D-6E8A-4147-A177-3AD203B41FA5}">
                      <a16:colId xmlns:a16="http://schemas.microsoft.com/office/drawing/2014/main" val="1606265207"/>
                    </a:ext>
                  </a:extLst>
                </a:gridCol>
                <a:gridCol w="795138">
                  <a:extLst>
                    <a:ext uri="{9D8B030D-6E8A-4147-A177-3AD203B41FA5}">
                      <a16:colId xmlns:a16="http://schemas.microsoft.com/office/drawing/2014/main" val="756424528"/>
                    </a:ext>
                  </a:extLst>
                </a:gridCol>
                <a:gridCol w="1110669">
                  <a:extLst>
                    <a:ext uri="{9D8B030D-6E8A-4147-A177-3AD203B41FA5}">
                      <a16:colId xmlns:a16="http://schemas.microsoft.com/office/drawing/2014/main" val="797543619"/>
                    </a:ext>
                  </a:extLst>
                </a:gridCol>
                <a:gridCol w="927662">
                  <a:extLst>
                    <a:ext uri="{9D8B030D-6E8A-4147-A177-3AD203B41FA5}">
                      <a16:colId xmlns:a16="http://schemas.microsoft.com/office/drawing/2014/main" val="4068524426"/>
                    </a:ext>
                  </a:extLst>
                </a:gridCol>
                <a:gridCol w="821958">
                  <a:extLst>
                    <a:ext uri="{9D8B030D-6E8A-4147-A177-3AD203B41FA5}">
                      <a16:colId xmlns:a16="http://schemas.microsoft.com/office/drawing/2014/main" val="2051736422"/>
                    </a:ext>
                  </a:extLst>
                </a:gridCol>
              </a:tblGrid>
              <a:tr h="1611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KCM (N = 48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TAD (N = 47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GCT (N = 15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HCA (N = 51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HYM (N = 12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CEC (N = 54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CS (N = 5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VM (N = 8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702822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kin Cutaneous Mela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Stomach Adeno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esticular Germ Cell Cancer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hyroid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Thym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terine Corpus Endometrial Carci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terine Carcinosarc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Uveal Melanoma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30327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FADS1 – mean (SD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1469 (0.925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534 (1.039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5240 (0.810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286 (1.058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130 (1.113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885 (1.090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-0.0599 (1.253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.0210 (0.968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606290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72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217001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Age – median (range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58 (15-90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67 (30-90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1 (14-6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6 (15-8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0 (17-8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4 (31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8 (51-90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61.5 (22-8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104535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Missing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9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7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0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54172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Race – no. (%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281318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54 (9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78 (5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24 (7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38 (66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03 (8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75 (68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4 (7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5 (69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025017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Non-Caucasian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6 (5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00 (4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2 (21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78 (34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1 (17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74 (32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3 (23)</a:t>
                      </a:r>
                      <a:endParaRPr lang="en-US" sz="105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25 (31)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247940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3036846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738" y="4063882"/>
            <a:ext cx="2743200" cy="21945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738" y="1617178"/>
            <a:ext cx="2743200" cy="21945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7217" y="1617178"/>
            <a:ext cx="2743200" cy="219456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679" y="3982318"/>
            <a:ext cx="2743200" cy="21945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E4C03CB-1D7C-4270-9108-F16C6F03C2F2}"/>
              </a:ext>
            </a:extLst>
          </p:cNvPr>
          <p:cNvSpPr/>
          <p:nvPr/>
        </p:nvSpPr>
        <p:spPr>
          <a:xfrm>
            <a:off x="463401" y="240418"/>
            <a:ext cx="8282763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I) KICH, J) KIRC, K) KIRP, L) LGG. 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 </a:t>
            </a:r>
            <a:r>
              <a:rPr lang="en-US" sz="1600" dirty="0"/>
              <a:t>FADS1 RNA expression level is normalized by z-score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5EBCE0-5496-4A40-BAE6-A59439A7066E}"/>
              </a:ext>
            </a:extLst>
          </p:cNvPr>
          <p:cNvSpPr txBox="1"/>
          <p:nvPr/>
        </p:nvSpPr>
        <p:spPr>
          <a:xfrm>
            <a:off x="1696552" y="152236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F8D602-C771-4003-8A9D-94230CF4CA6E}"/>
              </a:ext>
            </a:extLst>
          </p:cNvPr>
          <p:cNvSpPr txBox="1"/>
          <p:nvPr/>
        </p:nvSpPr>
        <p:spPr>
          <a:xfrm>
            <a:off x="5411014" y="1532286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FCC17E7-B88D-445C-99CD-B40B80BC33B0}"/>
              </a:ext>
            </a:extLst>
          </p:cNvPr>
          <p:cNvSpPr txBox="1"/>
          <p:nvPr/>
        </p:nvSpPr>
        <p:spPr>
          <a:xfrm>
            <a:off x="1696552" y="3963666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FA1468-0578-4055-8B8B-08851AC93D37}"/>
              </a:ext>
            </a:extLst>
          </p:cNvPr>
          <p:cNvSpPr txBox="1"/>
          <p:nvPr/>
        </p:nvSpPr>
        <p:spPr>
          <a:xfrm>
            <a:off x="5310525" y="3879216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118706552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057" y="1619280"/>
            <a:ext cx="3931920" cy="21945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7023" y="1619280"/>
            <a:ext cx="3931920" cy="21945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7761" y="4229973"/>
            <a:ext cx="2743200" cy="21945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1384" y="4229973"/>
            <a:ext cx="2743200" cy="21945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09241C4-B1BF-47F7-B811-F283E3CE3C55}"/>
              </a:ext>
            </a:extLst>
          </p:cNvPr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M) LIHC, N) LUAD, O) LUSC, P) OV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</a:t>
            </a:r>
            <a:endParaRPr lang="en-US" sz="1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11EBAD-A1AC-4630-9B70-CFE5975141E7}"/>
              </a:ext>
            </a:extLst>
          </p:cNvPr>
          <p:cNvSpPr txBox="1"/>
          <p:nvPr/>
        </p:nvSpPr>
        <p:spPr>
          <a:xfrm>
            <a:off x="900139" y="1487548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AF578C8-E4C1-4124-AE25-6EEC662A314F}"/>
              </a:ext>
            </a:extLst>
          </p:cNvPr>
          <p:cNvSpPr txBox="1"/>
          <p:nvPr/>
        </p:nvSpPr>
        <p:spPr>
          <a:xfrm>
            <a:off x="5094554" y="1487548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77C655-7511-4856-8C61-40B384DDD7C8}"/>
              </a:ext>
            </a:extLst>
          </p:cNvPr>
          <p:cNvSpPr txBox="1"/>
          <p:nvPr/>
        </p:nvSpPr>
        <p:spPr>
          <a:xfrm>
            <a:off x="1460252" y="4107468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FE089E-BD06-4E98-9AAD-15B57748C989}"/>
              </a:ext>
            </a:extLst>
          </p:cNvPr>
          <p:cNvSpPr txBox="1"/>
          <p:nvPr/>
        </p:nvSpPr>
        <p:spPr>
          <a:xfrm>
            <a:off x="5771761" y="4108018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207646048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401" y="1490570"/>
            <a:ext cx="3931920" cy="21945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0323" y="1477983"/>
            <a:ext cx="3931920" cy="21945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203" y="4243924"/>
            <a:ext cx="3931920" cy="219456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8774" y="4227975"/>
            <a:ext cx="4572000" cy="219456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CCED1FBB-2759-49A8-BD55-AD0A7F89D450}"/>
              </a:ext>
            </a:extLst>
          </p:cNvPr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Q) PAAD, R) PCPG, S) PRAD, T) SARC. 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</a:t>
            </a:r>
            <a:endParaRPr lang="en-US" sz="16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27EB46-30C0-44F4-9313-9C20CE80D881}"/>
              </a:ext>
            </a:extLst>
          </p:cNvPr>
          <p:cNvSpPr txBox="1"/>
          <p:nvPr/>
        </p:nvSpPr>
        <p:spPr>
          <a:xfrm>
            <a:off x="835532" y="136863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Q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F2750E-A28C-4D2C-B320-1DFA25D8C577}"/>
              </a:ext>
            </a:extLst>
          </p:cNvPr>
          <p:cNvSpPr txBox="1"/>
          <p:nvPr/>
        </p:nvSpPr>
        <p:spPr>
          <a:xfrm>
            <a:off x="5029947" y="136863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B3E4CB-9836-4198-BD8A-F1E811CD0E4D}"/>
              </a:ext>
            </a:extLst>
          </p:cNvPr>
          <p:cNvSpPr txBox="1"/>
          <p:nvPr/>
        </p:nvSpPr>
        <p:spPr>
          <a:xfrm>
            <a:off x="664125" y="413719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ADB05B-2752-43DE-A60D-A728B0724058}"/>
              </a:ext>
            </a:extLst>
          </p:cNvPr>
          <p:cNvSpPr txBox="1"/>
          <p:nvPr/>
        </p:nvSpPr>
        <p:spPr>
          <a:xfrm>
            <a:off x="4762396" y="4134862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</a:p>
        </p:txBody>
      </p:sp>
    </p:spTree>
    <p:extLst>
      <p:ext uri="{BB962C8B-B14F-4D97-AF65-F5344CB8AC3E}">
        <p14:creationId xmlns:p14="http://schemas.microsoft.com/office/powerpoint/2010/main" val="7083603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" y="1284838"/>
            <a:ext cx="3931920" cy="21945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4495" y="1284838"/>
            <a:ext cx="2743200" cy="21945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80" y="3845347"/>
            <a:ext cx="3931920" cy="21945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874" y="3807653"/>
            <a:ext cx="2743200" cy="21945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A760C58-1CE2-4870-B72F-7F0FC92CBF28}"/>
              </a:ext>
            </a:extLst>
          </p:cNvPr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 U) SKCM, V) STAD, W) THCA, X) THYM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</a:t>
            </a:r>
            <a:endParaRPr lang="en-US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E6498E-3504-4B32-BD81-8C6F798C73B3}"/>
              </a:ext>
            </a:extLst>
          </p:cNvPr>
          <p:cNvSpPr txBox="1"/>
          <p:nvPr/>
        </p:nvSpPr>
        <p:spPr>
          <a:xfrm>
            <a:off x="1022012" y="1171776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BCBAB2-4A33-4148-A383-079CCFC4C4BC}"/>
              </a:ext>
            </a:extLst>
          </p:cNvPr>
          <p:cNvSpPr txBox="1"/>
          <p:nvPr/>
        </p:nvSpPr>
        <p:spPr>
          <a:xfrm>
            <a:off x="5786881" y="1171776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94474A2-521B-4F6B-A7BC-B43EB880FA4B}"/>
              </a:ext>
            </a:extLst>
          </p:cNvPr>
          <p:cNvSpPr txBox="1"/>
          <p:nvPr/>
        </p:nvSpPr>
        <p:spPr>
          <a:xfrm>
            <a:off x="1034926" y="3765530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363D64-FE84-45A3-B71F-ACA3683DC9EF}"/>
              </a:ext>
            </a:extLst>
          </p:cNvPr>
          <p:cNvSpPr txBox="1"/>
          <p:nvPr/>
        </p:nvSpPr>
        <p:spPr>
          <a:xfrm>
            <a:off x="5780424" y="3692821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272252505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4682" y="1745370"/>
            <a:ext cx="3931920" cy="219456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E4ED2378-74E9-4B79-B465-0E61EEAF3D7E}"/>
              </a:ext>
            </a:extLst>
          </p:cNvPr>
          <p:cNvSpPr/>
          <p:nvPr/>
        </p:nvSpPr>
        <p:spPr>
          <a:xfrm>
            <a:off x="463401" y="240418"/>
            <a:ext cx="8282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inued- Supplementary Figure S4. The mRNA expression levels of FADS1 according to sample type for each cancer type. Y) UCEC 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-values were obtained from Wilcoxon-rank sum test or Kruskal-Wallis test.</a:t>
            </a:r>
            <a:endParaRPr lang="en-US" sz="16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35A69EB-3FC6-44BD-9A55-FA6F5986E0E5}"/>
              </a:ext>
            </a:extLst>
          </p:cNvPr>
          <p:cNvSpPr txBox="1"/>
          <p:nvPr/>
        </p:nvSpPr>
        <p:spPr>
          <a:xfrm>
            <a:off x="1866792" y="1560704"/>
            <a:ext cx="560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Y</a:t>
            </a:r>
          </a:p>
        </p:txBody>
      </p:sp>
    </p:spTree>
    <p:extLst>
      <p:ext uri="{BB962C8B-B14F-4D97-AF65-F5344CB8AC3E}">
        <p14:creationId xmlns:p14="http://schemas.microsoft.com/office/powerpoint/2010/main" val="383091078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1408" y="1738136"/>
            <a:ext cx="4508969" cy="338172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BF190D50-A58D-40E1-A7A4-6741A234DD9B}"/>
              </a:ext>
            </a:extLst>
          </p:cNvPr>
          <p:cNvSpPr/>
          <p:nvPr/>
        </p:nvSpPr>
        <p:spPr>
          <a:xfrm>
            <a:off x="463296" y="183172"/>
            <a:ext cx="827836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5. The mRNA expression levels of FADS1 according to sample type and TP53’s mutation status (mutated [MUT] vs. wild-type [WT]) in brain cancer types. </a:t>
            </a:r>
            <a:r>
              <a:rPr lang="en-US" sz="18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numbers in parentheses indicate the sample sizes and the p-values were obtained from post-hoc Wilcoxon-rank sum tests. </a:t>
            </a:r>
            <a:r>
              <a:rPr lang="en-US" sz="1800" dirty="0"/>
              <a:t>FADS1 RNA expression level is normalized by z-scor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749047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FA885B0-4B41-D0D7-944F-414B881DD5E0}"/>
              </a:ext>
            </a:extLst>
          </p:cNvPr>
          <p:cNvSpPr txBox="1"/>
          <p:nvPr/>
        </p:nvSpPr>
        <p:spPr>
          <a:xfrm>
            <a:off x="343989" y="418510"/>
            <a:ext cx="880001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a typeface="Calibri" panose="020F0502020204030204" pitchFamily="34" charset="0"/>
                <a:cs typeface="Arial" panose="020B0604020202020204" pitchFamily="34" charset="0"/>
              </a:rPr>
              <a:t>Supplementary Figure S6. Manhattan Plot of FADS1 SNPs in different cancer types. </a:t>
            </a:r>
            <a:r>
              <a:rPr lang="en-US" sz="1800" dirty="0">
                <a:effectLst/>
                <a:ea typeface="Calibri" panose="020F0502020204030204" pitchFamily="34" charset="0"/>
              </a:rPr>
              <a:t>Human genome reference GRCh38/hg38 is used to depict the location of SNPs</a:t>
            </a:r>
            <a:r>
              <a:rPr lang="en-US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800" dirty="0">
                <a:ea typeface="Calibri" panose="020F0502020204030204" pitchFamily="34" charset="0"/>
                <a:cs typeface="Arial" panose="020B0604020202020204" pitchFamily="34" charset="0"/>
              </a:rPr>
              <a:t>FADS1 locus +/- 1Mb). </a:t>
            </a:r>
            <a:endParaRPr lang="en-US" dirty="0"/>
          </a:p>
        </p:txBody>
      </p:sp>
      <p:pic>
        <p:nvPicPr>
          <p:cNvPr id="9" name="Picture 8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77EABCAA-35A8-701B-86E2-08BF5B509E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76"/>
          <a:stretch/>
        </p:blipFill>
        <p:spPr>
          <a:xfrm>
            <a:off x="171994" y="1488556"/>
            <a:ext cx="8800011" cy="49509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837069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44C57634-19E6-4071-AA24-B6AADF5CF459}"/>
              </a:ext>
            </a:extLst>
          </p:cNvPr>
          <p:cNvSpPr/>
          <p:nvPr/>
        </p:nvSpPr>
        <p:spPr>
          <a:xfrm>
            <a:off x="585216" y="405535"/>
            <a:ext cx="8217408" cy="3755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7. FADS1 mRNA expression level in stable 786-O cell lines.</a:t>
            </a:r>
            <a:endParaRPr lang="en-US" sz="28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C19EA38-C8CF-4B7C-8693-8F20BA9B75B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0751" y="1569364"/>
            <a:ext cx="3661954" cy="3517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1370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174C6C2-E271-9DE4-2182-748A02A46019}"/>
              </a:ext>
            </a:extLst>
          </p:cNvPr>
          <p:cNvSpPr/>
          <p:nvPr/>
        </p:nvSpPr>
        <p:spPr>
          <a:xfrm>
            <a:off x="641756" y="183580"/>
            <a:ext cx="786048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ea typeface="Calibri" panose="020F0502020204030204" pitchFamily="34" charset="0"/>
                <a:cs typeface="Arial" panose="020B0604020202020204" pitchFamily="34" charset="0"/>
              </a:rPr>
              <a:t>Supplementary Fig S8. FADS1 inhibitor treatment in 786-O Stable cells . </a:t>
            </a:r>
            <a:r>
              <a:rPr lang="en-US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ell proliferation after FADS1 inhibitor treatment  at 2µM for 4days. All experiments were performed in triplicates. **P&lt;0.01, ***P &lt; 0.001, ****P&lt;0.0001.</a:t>
            </a:r>
            <a:endParaRPr lang="en-US" sz="1800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dirty="0"/>
          </a:p>
        </p:txBody>
      </p:sp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2C78D614-0673-4B5E-95A4-E11C4346DF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230" y="1781552"/>
            <a:ext cx="6129540" cy="3294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192541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862BD2D-E9E5-4FA0-8249-541D6AFC8B3E}"/>
              </a:ext>
            </a:extLst>
          </p:cNvPr>
          <p:cNvSpPr/>
          <p:nvPr/>
        </p:nvSpPr>
        <p:spPr>
          <a:xfrm>
            <a:off x="637561" y="5731589"/>
            <a:ext cx="786048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 S9.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riched canonical pathways for genes associated with FADS1 KD in 786-O cell lin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D83F09E-D186-4D16-A39C-53277F1B1CFA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1078" y="714972"/>
            <a:ext cx="5293453" cy="5016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94955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3B74832-DF50-429A-B244-FF0892580C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3313611"/>
              </p:ext>
            </p:extLst>
          </p:nvPr>
        </p:nvGraphicFramePr>
        <p:xfrm>
          <a:off x="628645" y="737903"/>
          <a:ext cx="7886701" cy="120015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354935">
                  <a:extLst>
                    <a:ext uri="{9D8B030D-6E8A-4147-A177-3AD203B41FA5}">
                      <a16:colId xmlns:a16="http://schemas.microsoft.com/office/drawing/2014/main" val="3721445454"/>
                    </a:ext>
                  </a:extLst>
                </a:gridCol>
                <a:gridCol w="974796">
                  <a:extLst>
                    <a:ext uri="{9D8B030D-6E8A-4147-A177-3AD203B41FA5}">
                      <a16:colId xmlns:a16="http://schemas.microsoft.com/office/drawing/2014/main" val="2664465792"/>
                    </a:ext>
                  </a:extLst>
                </a:gridCol>
                <a:gridCol w="1608887">
                  <a:extLst>
                    <a:ext uri="{9D8B030D-6E8A-4147-A177-3AD203B41FA5}">
                      <a16:colId xmlns:a16="http://schemas.microsoft.com/office/drawing/2014/main" val="2398016943"/>
                    </a:ext>
                  </a:extLst>
                </a:gridCol>
                <a:gridCol w="679834">
                  <a:extLst>
                    <a:ext uri="{9D8B030D-6E8A-4147-A177-3AD203B41FA5}">
                      <a16:colId xmlns:a16="http://schemas.microsoft.com/office/drawing/2014/main" val="2895825526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2444019105"/>
                    </a:ext>
                  </a:extLst>
                </a:gridCol>
                <a:gridCol w="974796">
                  <a:extLst>
                    <a:ext uri="{9D8B030D-6E8A-4147-A177-3AD203B41FA5}">
                      <a16:colId xmlns:a16="http://schemas.microsoft.com/office/drawing/2014/main" val="2809077753"/>
                    </a:ext>
                  </a:extLst>
                </a:gridCol>
                <a:gridCol w="1608887">
                  <a:extLst>
                    <a:ext uri="{9D8B030D-6E8A-4147-A177-3AD203B41FA5}">
                      <a16:colId xmlns:a16="http://schemas.microsoft.com/office/drawing/2014/main" val="4038261946"/>
                    </a:ext>
                  </a:extLst>
                </a:gridCol>
                <a:gridCol w="659166">
                  <a:extLst>
                    <a:ext uri="{9D8B030D-6E8A-4147-A177-3AD203B41FA5}">
                      <a16:colId xmlns:a16="http://schemas.microsoft.com/office/drawing/2014/main" val="172417693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Univariab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ultivariab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9559328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vent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R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 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vent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R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 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92568976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ADS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645/797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60 (1.026-1.097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637/795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68 (1.033-1.10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3453195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278/925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10 (1.007-1.013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637/795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10 (1.006-1.013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52349356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a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075168728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1270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ucas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567/66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f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045/579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f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9755195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1270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Non-Caucas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719/258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1.010 (0.924-1.104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82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92/216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81 (0.979-1.19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12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52988170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10E7568-03BD-461B-B49E-BE9F53B20EC9}"/>
              </a:ext>
            </a:extLst>
          </p:cNvPr>
          <p:cNvSpPr/>
          <p:nvPr/>
        </p:nvSpPr>
        <p:spPr>
          <a:xfrm>
            <a:off x="549478" y="127743"/>
            <a:ext cx="81163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Table S3. Univariable and multivariable Cox regression analysis of risk factors associated with DFS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FE53648A-AA16-4794-B68A-9E7A7C1746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9472464"/>
              </p:ext>
            </p:extLst>
          </p:nvPr>
        </p:nvGraphicFramePr>
        <p:xfrm>
          <a:off x="628645" y="2890257"/>
          <a:ext cx="7886701" cy="1200150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340739">
                  <a:extLst>
                    <a:ext uri="{9D8B030D-6E8A-4147-A177-3AD203B41FA5}">
                      <a16:colId xmlns:a16="http://schemas.microsoft.com/office/drawing/2014/main" val="3088501316"/>
                    </a:ext>
                  </a:extLst>
                </a:gridCol>
                <a:gridCol w="1053663">
                  <a:extLst>
                    <a:ext uri="{9D8B030D-6E8A-4147-A177-3AD203B41FA5}">
                      <a16:colId xmlns:a16="http://schemas.microsoft.com/office/drawing/2014/main" val="489303918"/>
                    </a:ext>
                  </a:extLst>
                </a:gridCol>
                <a:gridCol w="1589959">
                  <a:extLst>
                    <a:ext uri="{9D8B030D-6E8A-4147-A177-3AD203B41FA5}">
                      <a16:colId xmlns:a16="http://schemas.microsoft.com/office/drawing/2014/main" val="3021052483"/>
                    </a:ext>
                  </a:extLst>
                </a:gridCol>
                <a:gridCol w="671947">
                  <a:extLst>
                    <a:ext uri="{9D8B030D-6E8A-4147-A177-3AD203B41FA5}">
                      <a16:colId xmlns:a16="http://schemas.microsoft.com/office/drawing/2014/main" val="3002740297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15916763"/>
                    </a:ext>
                  </a:extLst>
                </a:gridCol>
                <a:gridCol w="963755">
                  <a:extLst>
                    <a:ext uri="{9D8B030D-6E8A-4147-A177-3AD203B41FA5}">
                      <a16:colId xmlns:a16="http://schemas.microsoft.com/office/drawing/2014/main" val="1623989585"/>
                    </a:ext>
                  </a:extLst>
                </a:gridCol>
                <a:gridCol w="1589959">
                  <a:extLst>
                    <a:ext uri="{9D8B030D-6E8A-4147-A177-3AD203B41FA5}">
                      <a16:colId xmlns:a16="http://schemas.microsoft.com/office/drawing/2014/main" val="678665669"/>
                    </a:ext>
                  </a:extLst>
                </a:gridCol>
                <a:gridCol w="651279">
                  <a:extLst>
                    <a:ext uri="{9D8B030D-6E8A-4147-A177-3AD203B41FA5}">
                      <a16:colId xmlns:a16="http://schemas.microsoft.com/office/drawing/2014/main" val="519944702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Univariab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ultivariab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243972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vent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HR (95% CI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 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Event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HR (95% CI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 valu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5919476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FADS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805/929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32 (1.007-1.058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1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802/926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39 (1.013-1.064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0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53129358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3517/108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27 (1.024-1.03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802/926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25 (1.022-1.029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&lt;0.0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9059828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635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a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77016565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1270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ucasia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861/79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f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2272/684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Ref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6204263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marL="127000" marR="6350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Non-Caucasia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659/290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949 (0.868-1.037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0.24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530/242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1.044 (0.945-1.153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0.40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33823949"/>
                  </a:ext>
                </a:extLst>
              </a:tr>
            </a:tbl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8E92C679-263A-4497-A8CB-C43C0E952F30}"/>
              </a:ext>
            </a:extLst>
          </p:cNvPr>
          <p:cNvSpPr/>
          <p:nvPr/>
        </p:nvSpPr>
        <p:spPr>
          <a:xfrm>
            <a:off x="628645" y="4090407"/>
            <a:ext cx="7168916" cy="2496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000" dirty="0"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R, hazard ratio; CI, confidence interval. *, the number of events/the number of samples.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F4283CF-55DF-44AD-B9DA-460169DBFF37}"/>
              </a:ext>
            </a:extLst>
          </p:cNvPr>
          <p:cNvSpPr/>
          <p:nvPr/>
        </p:nvSpPr>
        <p:spPr>
          <a:xfrm>
            <a:off x="549478" y="2326353"/>
            <a:ext cx="81163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Table S4. Univariable and multivariable Cox regression analysis of risk factors associated with O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33078D7-E4D0-464D-A780-A01002CFD942}"/>
              </a:ext>
            </a:extLst>
          </p:cNvPr>
          <p:cNvSpPr/>
          <p:nvPr/>
        </p:nvSpPr>
        <p:spPr>
          <a:xfrm>
            <a:off x="628645" y="1882519"/>
            <a:ext cx="7168916" cy="2496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000" dirty="0">
                <a:latin typeface="Calibri" panose="020F050202020403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HR, hazard ratio; CI, confidence interval. *, the number of events/the number of samples.</a:t>
            </a:r>
          </a:p>
        </p:txBody>
      </p:sp>
    </p:spTree>
    <p:extLst>
      <p:ext uri="{BB962C8B-B14F-4D97-AF65-F5344CB8AC3E}">
        <p14:creationId xmlns:p14="http://schemas.microsoft.com/office/powerpoint/2010/main" val="1851500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D733E93-1D8B-4A64-8497-3F8077882117}"/>
              </a:ext>
            </a:extLst>
          </p:cNvPr>
          <p:cNvSpPr/>
          <p:nvPr/>
        </p:nvSpPr>
        <p:spPr>
          <a:xfrm>
            <a:off x="4818888" y="1651546"/>
            <a:ext cx="415139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S5. TCGA Cancer Abbreviation</a:t>
            </a:r>
            <a:endParaRPr lang="en-US" dirty="0"/>
          </a:p>
        </p:txBody>
      </p:sp>
      <p:graphicFrame>
        <p:nvGraphicFramePr>
          <p:cNvPr id="8" name="Content Placeholder 3">
            <a:extLst>
              <a:ext uri="{FF2B5EF4-FFF2-40B4-BE49-F238E27FC236}">
                <a16:creationId xmlns:a16="http://schemas.microsoft.com/office/drawing/2014/main" id="{825B15EA-33D7-4610-AE7B-11BBAC7847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1865650"/>
              </p:ext>
            </p:extLst>
          </p:nvPr>
        </p:nvGraphicFramePr>
        <p:xfrm>
          <a:off x="173715" y="302684"/>
          <a:ext cx="4398285" cy="634576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34470">
                  <a:extLst>
                    <a:ext uri="{9D8B030D-6E8A-4147-A177-3AD203B41FA5}">
                      <a16:colId xmlns:a16="http://schemas.microsoft.com/office/drawing/2014/main" val="1810633686"/>
                    </a:ext>
                  </a:extLst>
                </a:gridCol>
                <a:gridCol w="3263815">
                  <a:extLst>
                    <a:ext uri="{9D8B030D-6E8A-4147-A177-3AD203B41FA5}">
                      <a16:colId xmlns:a16="http://schemas.microsoft.com/office/drawing/2014/main" val="135671396"/>
                    </a:ext>
                  </a:extLst>
                </a:gridCol>
              </a:tblGrid>
              <a:tr h="33307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TCGA Cancer Abbreviation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CGA Cancer Full Nam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678697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drenocortica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51559672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L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ladder Urothelia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04840331"/>
                  </a:ext>
                </a:extLst>
              </a:tr>
              <a:tr h="20957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R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reast invasive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7394372"/>
                  </a:ext>
                </a:extLst>
              </a:tr>
              <a:tr h="25265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S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Cervical squamous cell carcinoma and endocervical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94322472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O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olangi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0488954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ADREA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lon adenocarcinoma - Rectum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0138814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B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ymphoid Neoplasm Diffuse Large B-cell Lymph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93537349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ophagea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1909193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B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lioblastoma multiforme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8821744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NS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d and Neck squamous cel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33657727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CH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dney Chromophobe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1369369"/>
                  </a:ext>
                </a:extLst>
              </a:tr>
              <a:tr h="17392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R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dney renal clear cel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59120754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R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idney renal papillary cel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2033165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AM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ute Myeloid Leukemi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04685729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G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rain Lower Grade Gli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78792607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H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ver hepatocellular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0825915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UA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ung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79238460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US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ung squamous cel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99306629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S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sotheli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5227079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V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varian serous cyst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94374143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A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ncreatic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9136285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CPG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heochromocytoma and Paragangli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34020655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A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state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6037894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R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rc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78876889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KC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kin Cutaneous Mela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71209196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omach adeno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96090011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GC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esticular Germ Cell Tumors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49890683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yroid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1277373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Y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ym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47154408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CE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terine Corpus Endometrial Carci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75764526"/>
                  </a:ext>
                </a:extLst>
              </a:tr>
              <a:tr h="1746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CS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terine Carcinosarc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80624544"/>
                  </a:ext>
                </a:extLst>
              </a:tr>
              <a:tr h="17392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VM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veal Melanom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2059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97866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135" y="1403985"/>
            <a:ext cx="3108960" cy="272034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4611" y="1403985"/>
            <a:ext cx="3108960" cy="272034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815" y="1399413"/>
            <a:ext cx="3114185" cy="272491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300" y="115861"/>
            <a:ext cx="8772525" cy="671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 lvl="0" algn="ctr" rtl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b="1" dirty="0"/>
              <a:t>Supplementary Figure S1. Kaplan-Meier (KM) plots of OS for each cancer type.  A) All Cancers, B) Brain cancers, C) Non-brain cancer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97E9769-98AA-4338-AEC3-EAFEACF623FE}"/>
              </a:ext>
            </a:extLst>
          </p:cNvPr>
          <p:cNvSpPr txBox="1"/>
          <p:nvPr/>
        </p:nvSpPr>
        <p:spPr>
          <a:xfrm>
            <a:off x="698703" y="124855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C873EB9-17BF-48B7-8567-CCE0BCB17C27}"/>
              </a:ext>
            </a:extLst>
          </p:cNvPr>
          <p:cNvSpPr txBox="1"/>
          <p:nvPr/>
        </p:nvSpPr>
        <p:spPr>
          <a:xfrm>
            <a:off x="3534919" y="1258077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6D3595-473C-4578-8815-6CE13A4AF0B2}"/>
              </a:ext>
            </a:extLst>
          </p:cNvPr>
          <p:cNvSpPr txBox="1"/>
          <p:nvPr/>
        </p:nvSpPr>
        <p:spPr>
          <a:xfrm>
            <a:off x="6607355" y="1262164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223595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8403"/>
            <a:ext cx="3108960" cy="272033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1391" y="884240"/>
            <a:ext cx="3108960" cy="272033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0448" y="872890"/>
            <a:ext cx="3108960" cy="272033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63083"/>
            <a:ext cx="3108960" cy="27203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1391" y="3915896"/>
            <a:ext cx="3108960" cy="2720336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0448" y="3963079"/>
            <a:ext cx="3108960" cy="27203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F375F29-5C31-403E-804D-E3E177B85756}"/>
              </a:ext>
            </a:extLst>
          </p:cNvPr>
          <p:cNvSpPr txBox="1"/>
          <p:nvPr/>
        </p:nvSpPr>
        <p:spPr>
          <a:xfrm>
            <a:off x="164592" y="115861"/>
            <a:ext cx="88148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1. Kaplan-Meier (KM) plots of OS for each cancer type. D) ACC, E)BLCA, F) BRCA, G) CESC, H) CHOL, I) COADREA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FF6A42-C8F1-4586-B048-000EF320A5C5}"/>
              </a:ext>
            </a:extLst>
          </p:cNvPr>
          <p:cNvSpPr txBox="1"/>
          <p:nvPr/>
        </p:nvSpPr>
        <p:spPr>
          <a:xfrm>
            <a:off x="540207" y="774698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E2E4BC-F053-4058-B152-D691AE42C17C}"/>
              </a:ext>
            </a:extLst>
          </p:cNvPr>
          <p:cNvSpPr txBox="1"/>
          <p:nvPr/>
        </p:nvSpPr>
        <p:spPr>
          <a:xfrm>
            <a:off x="3531598" y="76786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DE86EA-E848-4B21-A79E-BB8F9755E11B}"/>
              </a:ext>
            </a:extLst>
          </p:cNvPr>
          <p:cNvSpPr txBox="1"/>
          <p:nvPr/>
        </p:nvSpPr>
        <p:spPr>
          <a:xfrm>
            <a:off x="6433270" y="795906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432B38-ACC1-4849-9050-E39885ABCC9F}"/>
              </a:ext>
            </a:extLst>
          </p:cNvPr>
          <p:cNvSpPr txBox="1"/>
          <p:nvPr/>
        </p:nvSpPr>
        <p:spPr>
          <a:xfrm>
            <a:off x="540207" y="377841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407CF8E-4FB6-418F-8833-30C34632892C}"/>
              </a:ext>
            </a:extLst>
          </p:cNvPr>
          <p:cNvSpPr txBox="1"/>
          <p:nvPr/>
        </p:nvSpPr>
        <p:spPr>
          <a:xfrm>
            <a:off x="3578122" y="38579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41EC93-8316-4616-946C-95728956AC76}"/>
              </a:ext>
            </a:extLst>
          </p:cNvPr>
          <p:cNvSpPr txBox="1"/>
          <p:nvPr/>
        </p:nvSpPr>
        <p:spPr>
          <a:xfrm>
            <a:off x="6433270" y="38579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3534865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738" y="862500"/>
            <a:ext cx="3108960" cy="272034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343" y="827094"/>
            <a:ext cx="3108960" cy="27203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9885" y="813848"/>
            <a:ext cx="3099839" cy="272491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7" y="3773123"/>
            <a:ext cx="3108960" cy="27203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7024" y="3778893"/>
            <a:ext cx="3073444" cy="272491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9885" y="3770219"/>
            <a:ext cx="3108960" cy="27203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6FB8367-6279-443B-B879-B1F82424BE67}"/>
              </a:ext>
            </a:extLst>
          </p:cNvPr>
          <p:cNvSpPr txBox="1"/>
          <p:nvPr/>
        </p:nvSpPr>
        <p:spPr>
          <a:xfrm>
            <a:off x="204192" y="102615"/>
            <a:ext cx="8774653" cy="662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1. Kaplan-Meier (KM) plots of OS for each cancer type. J) DLBC, K) ESCA, L) GBM, M) HNSC, N) KICH, O) KIR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09B560-DB13-44D0-92AF-AE095FB429ED}"/>
              </a:ext>
            </a:extLst>
          </p:cNvPr>
          <p:cNvSpPr txBox="1"/>
          <p:nvPr/>
        </p:nvSpPr>
        <p:spPr>
          <a:xfrm>
            <a:off x="597408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1AE4DE4-6ED2-4AF6-99C3-E9A183309701}"/>
              </a:ext>
            </a:extLst>
          </p:cNvPr>
          <p:cNvSpPr txBox="1"/>
          <p:nvPr/>
        </p:nvSpPr>
        <p:spPr>
          <a:xfrm>
            <a:off x="3560064" y="84250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90FF66-0328-4141-873A-BEEEC67CCD20}"/>
              </a:ext>
            </a:extLst>
          </p:cNvPr>
          <p:cNvSpPr txBox="1"/>
          <p:nvPr/>
        </p:nvSpPr>
        <p:spPr>
          <a:xfrm>
            <a:off x="6470031" y="80060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D10B9EB-39B5-4861-B812-072DE1D16AFD}"/>
              </a:ext>
            </a:extLst>
          </p:cNvPr>
          <p:cNvSpPr txBox="1"/>
          <p:nvPr/>
        </p:nvSpPr>
        <p:spPr>
          <a:xfrm>
            <a:off x="597408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C559C6-2371-4744-A512-F99556363075}"/>
              </a:ext>
            </a:extLst>
          </p:cNvPr>
          <p:cNvSpPr txBox="1"/>
          <p:nvPr/>
        </p:nvSpPr>
        <p:spPr>
          <a:xfrm>
            <a:off x="3535680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6F0E714-0B50-485B-908F-69FF8F3EBCE5}"/>
              </a:ext>
            </a:extLst>
          </p:cNvPr>
          <p:cNvSpPr txBox="1"/>
          <p:nvPr/>
        </p:nvSpPr>
        <p:spPr>
          <a:xfrm>
            <a:off x="6494415" y="3718498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7387712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13" y="888229"/>
            <a:ext cx="3108960" cy="272034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7007" y="888229"/>
            <a:ext cx="3108960" cy="272034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4877" y="888229"/>
            <a:ext cx="3108960" cy="272034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" y="3802716"/>
            <a:ext cx="3108960" cy="272034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600" y="3738109"/>
            <a:ext cx="3108960" cy="272034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4020" y="3802716"/>
            <a:ext cx="3108960" cy="272034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883B11A-9EBD-4D23-91E9-F9A7455D710A}"/>
              </a:ext>
            </a:extLst>
          </p:cNvPr>
          <p:cNvSpPr txBox="1"/>
          <p:nvPr/>
        </p:nvSpPr>
        <p:spPr>
          <a:xfrm>
            <a:off x="204192" y="102615"/>
            <a:ext cx="8774653" cy="662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1. Kaplan-Meier (KM) plots of OS for each cancer type. P) KIRP, Q) LAML, R) LGG, S) LIHC, T) LUAD, U) LUS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D23485-1A0F-4170-9330-D18BB48D04EB}"/>
              </a:ext>
            </a:extLst>
          </p:cNvPr>
          <p:cNvSpPr txBox="1"/>
          <p:nvPr/>
        </p:nvSpPr>
        <p:spPr>
          <a:xfrm>
            <a:off x="597408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5C5212-2FFE-42EA-BF56-AF64B6243780}"/>
              </a:ext>
            </a:extLst>
          </p:cNvPr>
          <p:cNvSpPr txBox="1"/>
          <p:nvPr/>
        </p:nvSpPr>
        <p:spPr>
          <a:xfrm>
            <a:off x="3595520" y="894736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Q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8FDF95-A1F8-4320-ACE6-ECF8E1A92BEB}"/>
              </a:ext>
            </a:extLst>
          </p:cNvPr>
          <p:cNvSpPr txBox="1"/>
          <p:nvPr/>
        </p:nvSpPr>
        <p:spPr>
          <a:xfrm>
            <a:off x="6532114" y="809139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869C60-6C56-4A7F-9B1A-C3BBA0B13CE5}"/>
              </a:ext>
            </a:extLst>
          </p:cNvPr>
          <p:cNvSpPr txBox="1"/>
          <p:nvPr/>
        </p:nvSpPr>
        <p:spPr>
          <a:xfrm>
            <a:off x="597408" y="3787484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C46046-C641-48DD-A78A-D92A1F82411D}"/>
              </a:ext>
            </a:extLst>
          </p:cNvPr>
          <p:cNvSpPr txBox="1"/>
          <p:nvPr/>
        </p:nvSpPr>
        <p:spPr>
          <a:xfrm>
            <a:off x="3654116" y="373160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053E84-7B61-4BCD-8F6C-FDFB8AE62788}"/>
              </a:ext>
            </a:extLst>
          </p:cNvPr>
          <p:cNvSpPr txBox="1"/>
          <p:nvPr/>
        </p:nvSpPr>
        <p:spPr>
          <a:xfrm>
            <a:off x="6500948" y="3802716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</a:t>
            </a:r>
          </a:p>
        </p:txBody>
      </p:sp>
    </p:spTree>
    <p:extLst>
      <p:ext uri="{BB962C8B-B14F-4D97-AF65-F5344CB8AC3E}">
        <p14:creationId xmlns:p14="http://schemas.microsoft.com/office/powerpoint/2010/main" val="32156300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755" y="936125"/>
            <a:ext cx="3114185" cy="27249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4425" y="936125"/>
            <a:ext cx="3114185" cy="272491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2095" y="936125"/>
            <a:ext cx="3114185" cy="272491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31966"/>
            <a:ext cx="3114185" cy="272491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300" y="3831966"/>
            <a:ext cx="3146256" cy="2724912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3061" y="3831966"/>
            <a:ext cx="3114185" cy="272491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6757CE0-FC8A-4ACC-A223-19EF79379521}"/>
              </a:ext>
            </a:extLst>
          </p:cNvPr>
          <p:cNvSpPr txBox="1"/>
          <p:nvPr/>
        </p:nvSpPr>
        <p:spPr>
          <a:xfrm>
            <a:off x="204192" y="102615"/>
            <a:ext cx="8774653" cy="662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ontinued- Supplementary Figure S1. Kaplan-Meier (KM) plots of OS for each cancer type. V) OV, W) PAAD, X) PRAD, Y) SARC, Z) SKCM, AA) STA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C86D02-1A92-4716-8794-7A83FF22717D}"/>
              </a:ext>
            </a:extLst>
          </p:cNvPr>
          <p:cNvSpPr txBox="1"/>
          <p:nvPr/>
        </p:nvSpPr>
        <p:spPr>
          <a:xfrm>
            <a:off x="597408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17B0A2-F653-448C-8BA1-97195342C859}"/>
              </a:ext>
            </a:extLst>
          </p:cNvPr>
          <p:cNvSpPr txBox="1"/>
          <p:nvPr/>
        </p:nvSpPr>
        <p:spPr>
          <a:xfrm>
            <a:off x="3565289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60395C-C5AA-4A4D-8203-280DE232DDD0}"/>
              </a:ext>
            </a:extLst>
          </p:cNvPr>
          <p:cNvSpPr txBox="1"/>
          <p:nvPr/>
        </p:nvSpPr>
        <p:spPr>
          <a:xfrm>
            <a:off x="6416833" y="862500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417CE67-CC1B-46E4-B829-D69C2DA682D7}"/>
              </a:ext>
            </a:extLst>
          </p:cNvPr>
          <p:cNvSpPr txBox="1"/>
          <p:nvPr/>
        </p:nvSpPr>
        <p:spPr>
          <a:xfrm>
            <a:off x="589057" y="3708459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Y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344BCFD-F1FC-4CEE-B84A-EEF04FC1E1B5}"/>
              </a:ext>
            </a:extLst>
          </p:cNvPr>
          <p:cNvSpPr txBox="1"/>
          <p:nvPr/>
        </p:nvSpPr>
        <p:spPr>
          <a:xfrm>
            <a:off x="3410634" y="3734662"/>
            <a:ext cx="29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Z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2F34869-CEAF-4A5F-BB51-6C092FCB312F}"/>
              </a:ext>
            </a:extLst>
          </p:cNvPr>
          <p:cNvSpPr txBox="1"/>
          <p:nvPr/>
        </p:nvSpPr>
        <p:spPr>
          <a:xfrm>
            <a:off x="6416832" y="3831966"/>
            <a:ext cx="471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A</a:t>
            </a:r>
          </a:p>
        </p:txBody>
      </p:sp>
    </p:spTree>
    <p:extLst>
      <p:ext uri="{BB962C8B-B14F-4D97-AF65-F5344CB8AC3E}">
        <p14:creationId xmlns:p14="http://schemas.microsoft.com/office/powerpoint/2010/main" val="2673642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6775041997CE469D72B3E722C7FC1C" ma:contentTypeVersion="13" ma:contentTypeDescription="Create a new document." ma:contentTypeScope="" ma:versionID="a33a4283d0de573580182e70fe96e2e3">
  <xsd:schema xmlns:xsd="http://www.w3.org/2001/XMLSchema" xmlns:xs="http://www.w3.org/2001/XMLSchema" xmlns:p="http://schemas.microsoft.com/office/2006/metadata/properties" xmlns:ns3="e71d0e16-ebcb-4bea-9055-6d422f1e2e01" xmlns:ns4="39ec04d3-24f2-47de-ba78-3ca0251e400b" targetNamespace="http://schemas.microsoft.com/office/2006/metadata/properties" ma:root="true" ma:fieldsID="ded7654d02ed38e10e87de2f2831e080" ns3:_="" ns4:_="">
    <xsd:import namespace="e71d0e16-ebcb-4bea-9055-6d422f1e2e01"/>
    <xsd:import namespace="39ec04d3-24f2-47de-ba78-3ca0251e400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71d0e16-ebcb-4bea-9055-6d422f1e2e0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9ec04d3-24f2-47de-ba78-3ca0251e400b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FB3C127-EB30-463A-9C93-F229381CB0A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9CD32CD-B0ED-443A-8979-556EDBAA8385}">
  <ds:schemaRefs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e71d0e16-ebcb-4bea-9055-6d422f1e2e01"/>
    <ds:schemaRef ds:uri="http://schemas.microsoft.com/office/2006/metadata/properties"/>
    <ds:schemaRef ds:uri="http://purl.org/dc/terms/"/>
    <ds:schemaRef ds:uri="http://schemas.microsoft.com/office/2006/documentManagement/types"/>
    <ds:schemaRef ds:uri="39ec04d3-24f2-47de-ba78-3ca0251e400b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7367BDB2-19A6-41D3-BAAA-2E13BB1C332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71d0e16-ebcb-4bea-9055-6d422f1e2e01"/>
    <ds:schemaRef ds:uri="39ec04d3-24f2-47de-ba78-3ca0251e400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1</TotalTime>
  <Words>2638</Words>
  <Application>Microsoft Office PowerPoint</Application>
  <PresentationFormat>On-screen Show (4:3)</PresentationFormat>
  <Paragraphs>621</Paragraphs>
  <Slides>2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4" baseType="lpstr">
      <vt:lpstr>Arial</vt:lpstr>
      <vt:lpstr>Calibri</vt:lpstr>
      <vt:lpstr>Calibri Light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armanos Cancer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g, Hyejeong</dc:creator>
  <cp:lastModifiedBy>Gioia Heravi</cp:lastModifiedBy>
  <cp:revision>89</cp:revision>
  <dcterms:created xsi:type="dcterms:W3CDTF">2022-03-07T14:32:00Z</dcterms:created>
  <dcterms:modified xsi:type="dcterms:W3CDTF">2022-07-25T04:29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6775041997CE469D72B3E722C7FC1C</vt:lpwstr>
  </property>
</Properties>
</file>